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4.xml.rels" ContentType="application/vnd.openxmlformats-package.relationships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media/image27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4.png" ContentType="image/png"/>
  <Override PartName="/ppt/media/image1.png" ContentType="image/png"/>
  <Override PartName="/ppt/media/image31.png" ContentType="image/png"/>
  <Override PartName="/ppt/media/image25.png" ContentType="image/png"/>
  <Override PartName="/ppt/media/image2.png" ContentType="image/png"/>
  <Override PartName="/ppt/media/image32.png" ContentType="image/png"/>
  <Override PartName="/ppt/media/image4.wmf" ContentType="image/x-wmf"/>
  <Override PartName="/ppt/media/image13.png" ContentType="image/png"/>
  <Override PartName="/ppt/media/image40.png" ContentType="image/png"/>
  <Override PartName="/ppt/media/image34.png" ContentType="image/png"/>
  <Override PartName="/ppt/media/image9.png" ContentType="image/png"/>
  <Override PartName="/ppt/media/image39.png" ContentType="image/png"/>
  <Override PartName="/ppt/media/image41.png" ContentType="image/png"/>
  <Override PartName="/ppt/media/image30.png" ContentType="image/png"/>
  <Override PartName="/ppt/media/image28.png" ContentType="image/png"/>
  <Override PartName="/ppt/media/image42.png" ContentType="image/png"/>
  <Override PartName="/ppt/media/image43.png" ContentType="image/png"/>
  <Override PartName="/ppt/media/image44.png" ContentType="image/png"/>
  <Override PartName="/ppt/media/image45.png" ContentType="image/png"/>
  <Override PartName="/ppt/media/image46.png" ContentType="image/png"/>
  <Override PartName="/ppt/media/image38.png" ContentType="image/png"/>
  <Override PartName="/ppt/media/image8.png" ContentType="image/png"/>
  <Override PartName="/ppt/media/image12.png" ContentType="image/png"/>
  <Override PartName="/ppt/media/image10.png" ContentType="image/png"/>
  <Override PartName="/ppt/media/image47.png" ContentType="image/png"/>
  <Override PartName="/ppt/media/image11.wmf" ContentType="image/x-wmf"/>
  <Override PartName="/ppt/media/image33.png" ContentType="image/png"/>
  <Override PartName="/ppt/media/image3.png" ContentType="image/png"/>
  <Override PartName="/ppt/media/image26.png" ContentType="image/png"/>
  <Override PartName="/ppt/media/image37.png" ContentType="image/png"/>
  <Override PartName="/ppt/media/image7.png" ContentType="image/png"/>
  <Override PartName="/ppt/media/image36.png" ContentType="image/png"/>
  <Override PartName="/ppt/media/image6.png" ContentType="image/png"/>
  <Override PartName="/ppt/media/image29.png" ContentType="image/png"/>
  <Override PartName="/ppt/media/image5.png" ContentType="image/png"/>
  <Override PartName="/ppt/media/image35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371600" y="1142640"/>
            <a:ext cx="4114800" cy="3086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等线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DB24A40-79D6-4202-BBA8-B93E6A1D4E22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6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287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88" name="Slide Number Placeholder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3BECF3B-8AC1-4ADD-9EE3-03426054337F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9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290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91" name="Slide Number Placeholder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4D6D95D-7FC0-4596-A819-CA5B42565350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2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293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94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992AB88-7C7A-4BB9-8957-6E855CA7119D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C88573-26FD-4C17-9A70-AF83F0F5CCF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0B789A-3EF7-4F84-95A0-8B72357E1D4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025196-C2DC-430D-BE59-9356EE8E20D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4C0204-BB18-41A4-9663-28C9650BEBC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9251F9-39D4-4AEC-A64A-00393D19771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EFA10D-C8BF-4918-90DD-243B0AC1685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4C191C-7D07-47FF-832A-C858FE97E96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9D7046-C340-4E48-94EF-D15887A54FB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C9FD65-8C72-4FD8-9A5A-AA7CDE4BA8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83CC7B-1B09-421F-AF29-3DDD4FA21F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30A6D8-2867-4CFD-BAD6-5A48F363DF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4A8D4B-7CF9-4DFD-A5B3-D9385630AC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8E05D57-E22D-4758-AD52-970DB9FAE202}" type="slidenum">
              <a:rPr b="0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wmf"/><Relationship Id="rId9" Type="http://schemas.openxmlformats.org/officeDocument/2006/relationships/image" Target="../media/image5.png"/><Relationship Id="rId10" Type="http://schemas.openxmlformats.org/officeDocument/2006/relationships/image" Target="../media/image6.png"/><Relationship Id="rId11" Type="http://schemas.openxmlformats.org/officeDocument/2006/relationships/image" Target="../media/image7.png"/><Relationship Id="rId12" Type="http://schemas.openxmlformats.org/officeDocument/2006/relationships/image" Target="../media/image8.png"/><Relationship Id="rId13" Type="http://schemas.openxmlformats.org/officeDocument/2006/relationships/image" Target="../media/image9.png"/><Relationship Id="rId1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0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10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10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11.wmf"/><Relationship Id="rId9" Type="http://schemas.openxmlformats.org/officeDocument/2006/relationships/image" Target="../media/image12.png"/><Relationship Id="rId10" Type="http://schemas.openxmlformats.org/officeDocument/2006/relationships/image" Target="../media/image13.png"/><Relationship Id="rId11" Type="http://schemas.openxmlformats.org/officeDocument/2006/relationships/image" Target="../media/image14.png"/><Relationship Id="rId12" Type="http://schemas.openxmlformats.org/officeDocument/2006/relationships/image" Target="../media/image15.png"/><Relationship Id="rId13" Type="http://schemas.openxmlformats.org/officeDocument/2006/relationships/image" Target="../media/image16.png"/><Relationship Id="rId14" Type="http://schemas.openxmlformats.org/officeDocument/2006/relationships/slideLayout" Target="../slideLayouts/slideLayout1.xml"/><Relationship Id="rId15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image" Target="../media/image17.png"/><Relationship Id="rId3" Type="http://schemas.openxmlformats.org/officeDocument/2006/relationships/image" Target="../media/image18.png"/><Relationship Id="rId4" Type="http://schemas.openxmlformats.org/officeDocument/2006/relationships/image" Target="../media/image19.png"/><Relationship Id="rId5" Type="http://schemas.openxmlformats.org/officeDocument/2006/relationships/image" Target="../media/image20.png"/><Relationship Id="rId6" Type="http://schemas.openxmlformats.org/officeDocument/2006/relationships/image" Target="../media/image21.png"/><Relationship Id="rId7" Type="http://schemas.openxmlformats.org/officeDocument/2006/relationships/image" Target="../media/image22.png"/><Relationship Id="rId8" Type="http://schemas.openxmlformats.org/officeDocument/2006/relationships/image" Target="../media/image23.png"/><Relationship Id="rId9" Type="http://schemas.openxmlformats.org/officeDocument/2006/relationships/image" Target="../media/image24.png"/><Relationship Id="rId10" Type="http://schemas.openxmlformats.org/officeDocument/2006/relationships/image" Target="../media/image25.png"/><Relationship Id="rId11" Type="http://schemas.openxmlformats.org/officeDocument/2006/relationships/image" Target="../media/image26.png"/><Relationship Id="rId12" Type="http://schemas.openxmlformats.org/officeDocument/2006/relationships/image" Target="../media/image27.png"/><Relationship Id="rId13" Type="http://schemas.openxmlformats.org/officeDocument/2006/relationships/slideLayout" Target="../slideLayouts/slideLayout1.xml"/><Relationship Id="rId14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8.png"/><Relationship Id="rId2" Type="http://schemas.openxmlformats.org/officeDocument/2006/relationships/image" Target="../media/image29.png"/><Relationship Id="rId3" Type="http://schemas.openxmlformats.org/officeDocument/2006/relationships/image" Target="../media/image30.png"/><Relationship Id="rId4" Type="http://schemas.openxmlformats.org/officeDocument/2006/relationships/image" Target="../media/image31.png"/><Relationship Id="rId5" Type="http://schemas.openxmlformats.org/officeDocument/2006/relationships/image" Target="../media/image32.png"/><Relationship Id="rId6" Type="http://schemas.openxmlformats.org/officeDocument/2006/relationships/image" Target="../media/image33.png"/><Relationship Id="rId7" Type="http://schemas.openxmlformats.org/officeDocument/2006/relationships/image" Target="../media/image34.png"/><Relationship Id="rId8" Type="http://schemas.openxmlformats.org/officeDocument/2006/relationships/image" Target="../media/image35.png"/><Relationship Id="rId9" Type="http://schemas.openxmlformats.org/officeDocument/2006/relationships/image" Target="../media/image36.png"/><Relationship Id="rId10" Type="http://schemas.openxmlformats.org/officeDocument/2006/relationships/image" Target="../media/image37.png"/><Relationship Id="rId11" Type="http://schemas.openxmlformats.org/officeDocument/2006/relationships/slideLayout" Target="../slideLayouts/slideLayout1.xml"/><Relationship Id="rId12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38.png"/><Relationship Id="rId2" Type="http://schemas.openxmlformats.org/officeDocument/2006/relationships/image" Target="../media/image39.png"/><Relationship Id="rId3" Type="http://schemas.openxmlformats.org/officeDocument/2006/relationships/image" Target="../media/image40.png"/><Relationship Id="rId4" Type="http://schemas.openxmlformats.org/officeDocument/2006/relationships/image" Target="../media/image41.png"/><Relationship Id="rId5" Type="http://schemas.openxmlformats.org/officeDocument/2006/relationships/image" Target="../media/image42.png"/><Relationship Id="rId6" Type="http://schemas.openxmlformats.org/officeDocument/2006/relationships/image" Target="../media/image43.png"/><Relationship Id="rId7" Type="http://schemas.openxmlformats.org/officeDocument/2006/relationships/image" Target="../media/image44.png"/><Relationship Id="rId8" Type="http://schemas.openxmlformats.org/officeDocument/2006/relationships/image" Target="../media/image45.png"/><Relationship Id="rId9" Type="http://schemas.openxmlformats.org/officeDocument/2006/relationships/image" Target="../media/image46.png"/><Relationship Id="rId10" Type="http://schemas.openxmlformats.org/officeDocument/2006/relationships/image" Target="../media/image47.png"/><Relationship Id="rId1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对象 3"/>
          <p:cNvGraphicFramePr/>
          <p:nvPr/>
        </p:nvGraphicFramePr>
        <p:xfrm>
          <a:off x="-74520" y="0"/>
          <a:ext cx="2976480" cy="30924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9" name="对象 3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-74520" y="0"/>
                    <a:ext cx="2976480" cy="3092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0" name="对象 7"/>
          <p:cNvGraphicFramePr/>
          <p:nvPr/>
        </p:nvGraphicFramePr>
        <p:xfrm>
          <a:off x="2698920" y="-9360"/>
          <a:ext cx="2971800" cy="309240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51" name="对象 7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2698920" y="-9360"/>
                    <a:ext cx="2971800" cy="3092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2" name="对象 11"/>
          <p:cNvGraphicFramePr/>
          <p:nvPr/>
        </p:nvGraphicFramePr>
        <p:xfrm>
          <a:off x="-22320" y="2951280"/>
          <a:ext cx="2989440" cy="309240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53" name="对象 11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-22320" y="2951280"/>
                    <a:ext cx="2989440" cy="3092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4" name="对象 13"/>
          <p:cNvGraphicFramePr/>
          <p:nvPr/>
        </p:nvGraphicFramePr>
        <p:xfrm>
          <a:off x="2819520" y="3030480"/>
          <a:ext cx="3168360" cy="298296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55" name="对象 13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2819520" y="3030480"/>
                    <a:ext cx="3168360" cy="29829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pSp>
        <p:nvGrpSpPr>
          <p:cNvPr id="56" name="Group 2"/>
          <p:cNvGrpSpPr/>
          <p:nvPr/>
        </p:nvGrpSpPr>
        <p:grpSpPr>
          <a:xfrm>
            <a:off x="6035760" y="192240"/>
            <a:ext cx="3012840" cy="5600520"/>
            <a:chOff x="6035760" y="192240"/>
            <a:chExt cx="3012840" cy="5600520"/>
          </a:xfrm>
        </p:grpSpPr>
        <p:pic>
          <p:nvPicPr>
            <p:cNvPr id="57" name="图片 1" descr=""/>
            <p:cNvPicPr/>
            <p:nvPr/>
          </p:nvPicPr>
          <p:blipFill>
            <a:blip r:embed="rId9">
              <a:lum bright="18000"/>
            </a:blip>
            <a:srcRect l="54010" t="20627" r="23051" b="45760"/>
            <a:stretch/>
          </p:blipFill>
          <p:spPr>
            <a:xfrm>
              <a:off x="6035760" y="196920"/>
              <a:ext cx="1479600" cy="1414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8" name="图片 1" descr=""/>
            <p:cNvPicPr/>
            <p:nvPr/>
          </p:nvPicPr>
          <p:blipFill>
            <a:blip r:embed="rId10">
              <a:lum bright="12000"/>
            </a:blip>
            <a:srcRect l="48917" t="20721" r="22266" b="46752"/>
            <a:stretch/>
          </p:blipFill>
          <p:spPr>
            <a:xfrm>
              <a:off x="7589520" y="192240"/>
              <a:ext cx="1441440" cy="1419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9" name="图片 2" descr=""/>
            <p:cNvPicPr/>
            <p:nvPr/>
          </p:nvPicPr>
          <p:blipFill>
            <a:blip r:embed="rId11">
              <a:lum bright="6000"/>
            </a:blip>
            <a:srcRect l="0" t="0" r="69822" b="67783"/>
            <a:stretch/>
          </p:blipFill>
          <p:spPr>
            <a:xfrm>
              <a:off x="6045120" y="1899000"/>
              <a:ext cx="1469880" cy="1414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0" name="图片 1" descr=""/>
            <p:cNvPicPr/>
            <p:nvPr/>
          </p:nvPicPr>
          <p:blipFill>
            <a:blip r:embed="rId12">
              <a:lum bright="6000"/>
            </a:blip>
            <a:srcRect l="8666" t="66409" r="71974" b="2824"/>
            <a:stretch/>
          </p:blipFill>
          <p:spPr>
            <a:xfrm>
              <a:off x="7589520" y="1899000"/>
              <a:ext cx="1419120" cy="1432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1" name="文本框 3"/>
            <p:cNvSpPr/>
            <p:nvPr/>
          </p:nvSpPr>
          <p:spPr>
            <a:xfrm>
              <a:off x="6345000" y="1595520"/>
              <a:ext cx="27036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DMSO              A1541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文本框 4"/>
            <p:cNvSpPr/>
            <p:nvPr/>
          </p:nvSpPr>
          <p:spPr>
            <a:xfrm>
              <a:off x="6357240" y="3377520"/>
              <a:ext cx="2679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A1542                A154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文本框 5"/>
            <p:cNvSpPr/>
            <p:nvPr/>
          </p:nvSpPr>
          <p:spPr>
            <a:xfrm>
              <a:off x="6997320" y="5424480"/>
              <a:ext cx="13017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Cedrelon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4" name="Picture 1" descr=""/>
            <p:cNvPicPr/>
            <p:nvPr/>
          </p:nvPicPr>
          <p:blipFill>
            <a:blip r:embed="rId13"/>
            <a:stretch/>
          </p:blipFill>
          <p:spPr>
            <a:xfrm>
              <a:off x="6678360" y="3792240"/>
              <a:ext cx="1822320" cy="161568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65" name="TextBox 15"/>
          <p:cNvSpPr/>
          <p:nvPr/>
        </p:nvSpPr>
        <p:spPr>
          <a:xfrm>
            <a:off x="13320" y="4428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16"/>
          <p:cNvSpPr/>
          <p:nvPr/>
        </p:nvSpPr>
        <p:spPr>
          <a:xfrm>
            <a:off x="5502960" y="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1"/>
          <p:cNvSpPr/>
          <p:nvPr/>
        </p:nvSpPr>
        <p:spPr>
          <a:xfrm>
            <a:off x="-44280" y="6022800"/>
            <a:ext cx="90532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l Figure 1: Growth inhibition of HEL cells by the compounds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(A) HEL cells were treated with the indicated concentration of the compounds and percentage of inhibition was determined by MTT assay 3 days after drug treatment.(B) Microscopic images of the cells after 2 days treatment with the indicated compounds (magnification x40). P&lt; 0.005 denoted by **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8" name="Group 8"/>
          <p:cNvGrpSpPr/>
          <p:nvPr/>
        </p:nvGrpSpPr>
        <p:grpSpPr>
          <a:xfrm>
            <a:off x="826920" y="312840"/>
            <a:ext cx="1657440" cy="474480"/>
            <a:chOff x="826920" y="312840"/>
            <a:chExt cx="1657440" cy="474480"/>
          </a:xfrm>
        </p:grpSpPr>
        <p:sp>
          <p:nvSpPr>
            <p:cNvPr id="69" name="Straight Connector 2"/>
            <p:cNvSpPr/>
            <p:nvPr/>
          </p:nvSpPr>
          <p:spPr>
            <a:xfrm>
              <a:off x="826920" y="546120"/>
              <a:ext cx="16574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Straight Connector 6"/>
            <p:cNvSpPr/>
            <p:nvPr/>
          </p:nvSpPr>
          <p:spPr>
            <a:xfrm>
              <a:off x="836280" y="549360"/>
              <a:ext cx="0" cy="237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Straight Connector 23"/>
            <p:cNvSpPr/>
            <p:nvPr/>
          </p:nvSpPr>
          <p:spPr>
            <a:xfrm>
              <a:off x="1425240" y="549360"/>
              <a:ext cx="0" cy="237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Straight Connector 24"/>
            <p:cNvSpPr/>
            <p:nvPr/>
          </p:nvSpPr>
          <p:spPr>
            <a:xfrm>
              <a:off x="1979640" y="549360"/>
              <a:ext cx="0" cy="237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Straight Connector 25"/>
            <p:cNvSpPr/>
            <p:nvPr/>
          </p:nvSpPr>
          <p:spPr>
            <a:xfrm>
              <a:off x="2413080" y="549360"/>
              <a:ext cx="0" cy="237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TextBox 7"/>
            <p:cNvSpPr/>
            <p:nvPr/>
          </p:nvSpPr>
          <p:spPr>
            <a:xfrm>
              <a:off x="1453320" y="312840"/>
              <a:ext cx="357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*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5" name="Group 28"/>
          <p:cNvGrpSpPr/>
          <p:nvPr/>
        </p:nvGrpSpPr>
        <p:grpSpPr>
          <a:xfrm>
            <a:off x="3621240" y="307800"/>
            <a:ext cx="1655640" cy="474840"/>
            <a:chOff x="3621240" y="307800"/>
            <a:chExt cx="1655640" cy="474840"/>
          </a:xfrm>
        </p:grpSpPr>
        <p:sp>
          <p:nvSpPr>
            <p:cNvPr id="76" name="Straight Connector 29"/>
            <p:cNvSpPr/>
            <p:nvPr/>
          </p:nvSpPr>
          <p:spPr>
            <a:xfrm>
              <a:off x="3621240" y="541080"/>
              <a:ext cx="1655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Straight Connector 30"/>
            <p:cNvSpPr/>
            <p:nvPr/>
          </p:nvSpPr>
          <p:spPr>
            <a:xfrm>
              <a:off x="3630600" y="544320"/>
              <a:ext cx="0" cy="2383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Straight Connector 31"/>
            <p:cNvSpPr/>
            <p:nvPr/>
          </p:nvSpPr>
          <p:spPr>
            <a:xfrm>
              <a:off x="4176720" y="544320"/>
              <a:ext cx="0" cy="2383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Straight Connector 32"/>
            <p:cNvSpPr/>
            <p:nvPr/>
          </p:nvSpPr>
          <p:spPr>
            <a:xfrm>
              <a:off x="4705560" y="544320"/>
              <a:ext cx="0" cy="2383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Straight Connector 33"/>
            <p:cNvSpPr/>
            <p:nvPr/>
          </p:nvSpPr>
          <p:spPr>
            <a:xfrm>
              <a:off x="5205600" y="544320"/>
              <a:ext cx="0" cy="2383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Box 34"/>
            <p:cNvSpPr/>
            <p:nvPr/>
          </p:nvSpPr>
          <p:spPr>
            <a:xfrm>
              <a:off x="4246920" y="307800"/>
              <a:ext cx="357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*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2" name="Group 35"/>
          <p:cNvGrpSpPr/>
          <p:nvPr/>
        </p:nvGrpSpPr>
        <p:grpSpPr>
          <a:xfrm>
            <a:off x="903240" y="3260880"/>
            <a:ext cx="1655640" cy="474480"/>
            <a:chOff x="903240" y="3260880"/>
            <a:chExt cx="1655640" cy="474480"/>
          </a:xfrm>
        </p:grpSpPr>
        <p:sp>
          <p:nvSpPr>
            <p:cNvPr id="83" name="Straight Connector 36"/>
            <p:cNvSpPr/>
            <p:nvPr/>
          </p:nvSpPr>
          <p:spPr>
            <a:xfrm>
              <a:off x="903240" y="3494160"/>
              <a:ext cx="1655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Straight Connector 37"/>
            <p:cNvSpPr/>
            <p:nvPr/>
          </p:nvSpPr>
          <p:spPr>
            <a:xfrm>
              <a:off x="912600" y="3497400"/>
              <a:ext cx="0" cy="237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Straight Connector 38"/>
            <p:cNvSpPr/>
            <p:nvPr/>
          </p:nvSpPr>
          <p:spPr>
            <a:xfrm>
              <a:off x="1458720" y="3497400"/>
              <a:ext cx="0" cy="237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Straight Connector 39"/>
            <p:cNvSpPr/>
            <p:nvPr/>
          </p:nvSpPr>
          <p:spPr>
            <a:xfrm>
              <a:off x="1987560" y="3497400"/>
              <a:ext cx="0" cy="237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Straight Connector 40"/>
            <p:cNvSpPr/>
            <p:nvPr/>
          </p:nvSpPr>
          <p:spPr>
            <a:xfrm>
              <a:off x="2487600" y="3497400"/>
              <a:ext cx="0" cy="237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TextBox 41"/>
            <p:cNvSpPr/>
            <p:nvPr/>
          </p:nvSpPr>
          <p:spPr>
            <a:xfrm>
              <a:off x="1528920" y="3260880"/>
              <a:ext cx="357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*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9" name="Group 42"/>
          <p:cNvGrpSpPr/>
          <p:nvPr/>
        </p:nvGrpSpPr>
        <p:grpSpPr>
          <a:xfrm>
            <a:off x="3780000" y="3276720"/>
            <a:ext cx="1655640" cy="474480"/>
            <a:chOff x="3780000" y="3276720"/>
            <a:chExt cx="1655640" cy="474480"/>
          </a:xfrm>
        </p:grpSpPr>
        <p:sp>
          <p:nvSpPr>
            <p:cNvPr id="90" name="Straight Connector 43"/>
            <p:cNvSpPr/>
            <p:nvPr/>
          </p:nvSpPr>
          <p:spPr>
            <a:xfrm>
              <a:off x="3780000" y="3510000"/>
              <a:ext cx="1655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Straight Connector 44"/>
            <p:cNvSpPr/>
            <p:nvPr/>
          </p:nvSpPr>
          <p:spPr>
            <a:xfrm>
              <a:off x="3789360" y="3513240"/>
              <a:ext cx="0" cy="237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Straight Connector 45"/>
            <p:cNvSpPr/>
            <p:nvPr/>
          </p:nvSpPr>
          <p:spPr>
            <a:xfrm>
              <a:off x="4419720" y="3513240"/>
              <a:ext cx="0" cy="237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Straight Connector 46"/>
            <p:cNvSpPr/>
            <p:nvPr/>
          </p:nvSpPr>
          <p:spPr>
            <a:xfrm>
              <a:off x="4932360" y="3513240"/>
              <a:ext cx="0" cy="237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Straight Connector 47"/>
            <p:cNvSpPr/>
            <p:nvPr/>
          </p:nvSpPr>
          <p:spPr>
            <a:xfrm>
              <a:off x="5364360" y="3513240"/>
              <a:ext cx="0" cy="237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TextBox 48"/>
            <p:cNvSpPr/>
            <p:nvPr/>
          </p:nvSpPr>
          <p:spPr>
            <a:xfrm>
              <a:off x="4405680" y="3276720"/>
              <a:ext cx="357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*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6" name="对象 1"/>
          <p:cNvGraphicFramePr/>
          <p:nvPr/>
        </p:nvGraphicFramePr>
        <p:xfrm>
          <a:off x="0" y="63360"/>
          <a:ext cx="3205080" cy="31291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97" name="对象 1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0" y="63360"/>
                    <a:ext cx="3205080" cy="3129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98" name="对象 3"/>
          <p:cNvGraphicFramePr/>
          <p:nvPr/>
        </p:nvGraphicFramePr>
        <p:xfrm>
          <a:off x="2984400" y="66600"/>
          <a:ext cx="3187800" cy="312912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99" name="对象 3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2984400" y="66600"/>
                    <a:ext cx="3187800" cy="3129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00" name="对象 5"/>
          <p:cNvGraphicFramePr/>
          <p:nvPr/>
        </p:nvGraphicFramePr>
        <p:xfrm>
          <a:off x="6480" y="3189240"/>
          <a:ext cx="3205080" cy="312912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101" name="对象 5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6480" y="3189240"/>
                    <a:ext cx="3205080" cy="3129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02" name="对象 7"/>
          <p:cNvGraphicFramePr/>
          <p:nvPr/>
        </p:nvGraphicFramePr>
        <p:xfrm>
          <a:off x="3132000" y="3151080"/>
          <a:ext cx="3086280" cy="309096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103" name="对象 7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3132000" y="3151080"/>
                    <a:ext cx="3086280" cy="30909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pSp>
        <p:nvGrpSpPr>
          <p:cNvPr id="104" name="Group 8"/>
          <p:cNvGrpSpPr/>
          <p:nvPr/>
        </p:nvGrpSpPr>
        <p:grpSpPr>
          <a:xfrm>
            <a:off x="6165720" y="208080"/>
            <a:ext cx="3060720" cy="5562720"/>
            <a:chOff x="6165720" y="208080"/>
            <a:chExt cx="3060720" cy="5562720"/>
          </a:xfrm>
        </p:grpSpPr>
        <p:sp>
          <p:nvSpPr>
            <p:cNvPr id="105" name="文本框 3"/>
            <p:cNvSpPr/>
            <p:nvPr/>
          </p:nvSpPr>
          <p:spPr>
            <a:xfrm>
              <a:off x="6522840" y="1637280"/>
              <a:ext cx="27036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DMSO              A1541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文本框 1"/>
            <p:cNvSpPr/>
            <p:nvPr/>
          </p:nvSpPr>
          <p:spPr>
            <a:xfrm>
              <a:off x="6364440" y="3547440"/>
              <a:ext cx="1243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A1542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文本框 2"/>
            <p:cNvSpPr/>
            <p:nvPr/>
          </p:nvSpPr>
          <p:spPr>
            <a:xfrm>
              <a:off x="7954200" y="3547440"/>
              <a:ext cx="102060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A1543          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文本框 5"/>
            <p:cNvSpPr/>
            <p:nvPr/>
          </p:nvSpPr>
          <p:spPr>
            <a:xfrm>
              <a:off x="6998760" y="5402520"/>
              <a:ext cx="13017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Cedrelon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09" name="Picture 2" descr=""/>
            <p:cNvPicPr/>
            <p:nvPr/>
          </p:nvPicPr>
          <p:blipFill>
            <a:blip r:embed="rId9"/>
            <a:stretch/>
          </p:blipFill>
          <p:spPr>
            <a:xfrm>
              <a:off x="6165720" y="215640"/>
              <a:ext cx="1436040" cy="1461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0" name="Picture 3" descr=""/>
            <p:cNvPicPr/>
            <p:nvPr/>
          </p:nvPicPr>
          <p:blipFill>
            <a:blip r:embed="rId10"/>
            <a:stretch/>
          </p:blipFill>
          <p:spPr>
            <a:xfrm>
              <a:off x="7649640" y="208080"/>
              <a:ext cx="1436040" cy="1461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1" name="Picture 4" descr=""/>
            <p:cNvPicPr/>
            <p:nvPr/>
          </p:nvPicPr>
          <p:blipFill>
            <a:blip r:embed="rId11"/>
            <a:stretch/>
          </p:blipFill>
          <p:spPr>
            <a:xfrm>
              <a:off x="6178680" y="2096640"/>
              <a:ext cx="1436040" cy="1422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2" name="Picture 7" descr=""/>
            <p:cNvPicPr/>
            <p:nvPr/>
          </p:nvPicPr>
          <p:blipFill>
            <a:blip r:embed="rId12"/>
            <a:stretch/>
          </p:blipFill>
          <p:spPr>
            <a:xfrm>
              <a:off x="6918840" y="3979800"/>
              <a:ext cx="1397520" cy="1422360"/>
            </a:xfrm>
            <a:prstGeom prst="rect">
              <a:avLst/>
            </a:prstGeom>
            <a:ln w="0">
              <a:noFill/>
            </a:ln>
          </p:spPr>
        </p:pic>
      </p:grpSp>
      <p:pic>
        <p:nvPicPr>
          <p:cNvPr id="113" name="Picture 2" descr=""/>
          <p:cNvPicPr/>
          <p:nvPr/>
        </p:nvPicPr>
        <p:blipFill>
          <a:blip r:embed="rId13"/>
          <a:srcRect l="0" t="0" r="0" b="15640"/>
          <a:stretch/>
        </p:blipFill>
        <p:spPr>
          <a:xfrm>
            <a:off x="7666200" y="2104920"/>
            <a:ext cx="1442880" cy="1400400"/>
          </a:xfrm>
          <a:prstGeom prst="rect">
            <a:avLst/>
          </a:prstGeom>
          <a:ln w="0">
            <a:noFill/>
          </a:ln>
        </p:spPr>
      </p:pic>
      <p:sp>
        <p:nvSpPr>
          <p:cNvPr id="114" name="TextBox 1"/>
          <p:cNvSpPr/>
          <p:nvPr/>
        </p:nvSpPr>
        <p:spPr>
          <a:xfrm>
            <a:off x="13320" y="4428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Box 17"/>
          <p:cNvSpPr/>
          <p:nvPr/>
        </p:nvSpPr>
        <p:spPr>
          <a:xfrm>
            <a:off x="5723640" y="3348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Box 1"/>
          <p:cNvSpPr/>
          <p:nvPr/>
        </p:nvSpPr>
        <p:spPr>
          <a:xfrm>
            <a:off x="108000" y="6210360"/>
            <a:ext cx="897732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l Figure 2: Growth inhibition of CB3 cells by the compounds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(A) HEL cells were treated with the indicated concentration of the compounds and percentage of inhibition was determined by MTT assay 3 days after drug treatment.(B) Microscopic images of the cells after 2 days treatment with the indicated compounds (magnification x40). P&lt; 0.005 denoted by **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7" name="Group 3"/>
          <p:cNvGrpSpPr/>
          <p:nvPr/>
        </p:nvGrpSpPr>
        <p:grpSpPr>
          <a:xfrm>
            <a:off x="838080" y="301680"/>
            <a:ext cx="2005200" cy="485640"/>
            <a:chOff x="838080" y="301680"/>
            <a:chExt cx="2005200" cy="485640"/>
          </a:xfrm>
        </p:grpSpPr>
        <p:grpSp>
          <p:nvGrpSpPr>
            <p:cNvPr id="118" name="Group 20"/>
            <p:cNvGrpSpPr/>
            <p:nvPr/>
          </p:nvGrpSpPr>
          <p:grpSpPr>
            <a:xfrm>
              <a:off x="838080" y="301680"/>
              <a:ext cx="2000880" cy="475200"/>
              <a:chOff x="838080" y="301680"/>
              <a:chExt cx="2000880" cy="475200"/>
            </a:xfrm>
          </p:grpSpPr>
          <p:sp>
            <p:nvSpPr>
              <p:cNvPr id="119" name="Straight Connector 21"/>
              <p:cNvSpPr/>
              <p:nvPr/>
            </p:nvSpPr>
            <p:spPr>
              <a:xfrm>
                <a:off x="838080" y="535320"/>
                <a:ext cx="2000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Straight Connector 22"/>
              <p:cNvSpPr/>
              <p:nvPr/>
            </p:nvSpPr>
            <p:spPr>
              <a:xfrm>
                <a:off x="848880" y="538560"/>
                <a:ext cx="0" cy="2383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Straight Connector 23"/>
              <p:cNvSpPr/>
              <p:nvPr/>
            </p:nvSpPr>
            <p:spPr>
              <a:xfrm>
                <a:off x="1374840" y="538560"/>
                <a:ext cx="0" cy="2383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Straight Connector 24"/>
              <p:cNvSpPr/>
              <p:nvPr/>
            </p:nvSpPr>
            <p:spPr>
              <a:xfrm>
                <a:off x="1879920" y="538560"/>
                <a:ext cx="0" cy="2383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Straight Connector 25"/>
              <p:cNvSpPr/>
              <p:nvPr/>
            </p:nvSpPr>
            <p:spPr>
              <a:xfrm>
                <a:off x="2383200" y="538560"/>
                <a:ext cx="0" cy="2383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TextBox 26"/>
              <p:cNvSpPr/>
              <p:nvPr/>
            </p:nvSpPr>
            <p:spPr>
              <a:xfrm>
                <a:off x="1631520" y="301680"/>
                <a:ext cx="3574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**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5" name="Straight Connector 27"/>
            <p:cNvSpPr/>
            <p:nvPr/>
          </p:nvSpPr>
          <p:spPr>
            <a:xfrm>
              <a:off x="2843280" y="549360"/>
              <a:ext cx="0" cy="237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6" name="Group 36"/>
          <p:cNvGrpSpPr/>
          <p:nvPr/>
        </p:nvGrpSpPr>
        <p:grpSpPr>
          <a:xfrm>
            <a:off x="3824280" y="306360"/>
            <a:ext cx="2006640" cy="484200"/>
            <a:chOff x="3824280" y="306360"/>
            <a:chExt cx="2006640" cy="484200"/>
          </a:xfrm>
        </p:grpSpPr>
        <p:grpSp>
          <p:nvGrpSpPr>
            <p:cNvPr id="127" name="Group 37"/>
            <p:cNvGrpSpPr/>
            <p:nvPr/>
          </p:nvGrpSpPr>
          <p:grpSpPr>
            <a:xfrm>
              <a:off x="3824280" y="306360"/>
              <a:ext cx="2002320" cy="474120"/>
              <a:chOff x="3824280" y="306360"/>
              <a:chExt cx="2002320" cy="474120"/>
            </a:xfrm>
          </p:grpSpPr>
          <p:sp>
            <p:nvSpPr>
              <p:cNvPr id="128" name="Straight Connector 39"/>
              <p:cNvSpPr/>
              <p:nvPr/>
            </p:nvSpPr>
            <p:spPr>
              <a:xfrm>
                <a:off x="3824280" y="538560"/>
                <a:ext cx="20023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Straight Connector 40"/>
              <p:cNvSpPr/>
              <p:nvPr/>
            </p:nvSpPr>
            <p:spPr>
              <a:xfrm>
                <a:off x="3835080" y="541800"/>
                <a:ext cx="0" cy="238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Straight Connector 41"/>
              <p:cNvSpPr/>
              <p:nvPr/>
            </p:nvSpPr>
            <p:spPr>
              <a:xfrm>
                <a:off x="4362480" y="541800"/>
                <a:ext cx="0" cy="238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Straight Connector 42"/>
              <p:cNvSpPr/>
              <p:nvPr/>
            </p:nvSpPr>
            <p:spPr>
              <a:xfrm>
                <a:off x="4867560" y="541800"/>
                <a:ext cx="0" cy="238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Straight Connector 43"/>
              <p:cNvSpPr/>
              <p:nvPr/>
            </p:nvSpPr>
            <p:spPr>
              <a:xfrm>
                <a:off x="5370840" y="541800"/>
                <a:ext cx="0" cy="238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TextBox 44"/>
              <p:cNvSpPr/>
              <p:nvPr/>
            </p:nvSpPr>
            <p:spPr>
              <a:xfrm>
                <a:off x="4618800" y="306360"/>
                <a:ext cx="3574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**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34" name="Straight Connector 38"/>
            <p:cNvSpPr/>
            <p:nvPr/>
          </p:nvSpPr>
          <p:spPr>
            <a:xfrm>
              <a:off x="5830920" y="552600"/>
              <a:ext cx="0" cy="237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35" name="Group 45"/>
          <p:cNvGrpSpPr/>
          <p:nvPr/>
        </p:nvGrpSpPr>
        <p:grpSpPr>
          <a:xfrm>
            <a:off x="860400" y="3408480"/>
            <a:ext cx="2005200" cy="484200"/>
            <a:chOff x="860400" y="3408480"/>
            <a:chExt cx="2005200" cy="484200"/>
          </a:xfrm>
        </p:grpSpPr>
        <p:grpSp>
          <p:nvGrpSpPr>
            <p:cNvPr id="136" name="Group 46"/>
            <p:cNvGrpSpPr/>
            <p:nvPr/>
          </p:nvGrpSpPr>
          <p:grpSpPr>
            <a:xfrm>
              <a:off x="860400" y="3408480"/>
              <a:ext cx="2000880" cy="474120"/>
              <a:chOff x="860400" y="3408480"/>
              <a:chExt cx="2000880" cy="474120"/>
            </a:xfrm>
          </p:grpSpPr>
          <p:sp>
            <p:nvSpPr>
              <p:cNvPr id="137" name="Straight Connector 48"/>
              <p:cNvSpPr/>
              <p:nvPr/>
            </p:nvSpPr>
            <p:spPr>
              <a:xfrm>
                <a:off x="860400" y="3640680"/>
                <a:ext cx="2000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Straight Connector 49"/>
              <p:cNvSpPr/>
              <p:nvPr/>
            </p:nvSpPr>
            <p:spPr>
              <a:xfrm>
                <a:off x="871200" y="3643920"/>
                <a:ext cx="0" cy="238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Straight Connector 50"/>
              <p:cNvSpPr/>
              <p:nvPr/>
            </p:nvSpPr>
            <p:spPr>
              <a:xfrm>
                <a:off x="1397160" y="3643920"/>
                <a:ext cx="0" cy="238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Straight Connector 51"/>
              <p:cNvSpPr/>
              <p:nvPr/>
            </p:nvSpPr>
            <p:spPr>
              <a:xfrm>
                <a:off x="1902240" y="3643920"/>
                <a:ext cx="0" cy="238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Straight Connector 52"/>
              <p:cNvSpPr/>
              <p:nvPr/>
            </p:nvSpPr>
            <p:spPr>
              <a:xfrm>
                <a:off x="2405520" y="3643920"/>
                <a:ext cx="0" cy="238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TextBox 53"/>
              <p:cNvSpPr/>
              <p:nvPr/>
            </p:nvSpPr>
            <p:spPr>
              <a:xfrm>
                <a:off x="1653840" y="3408480"/>
                <a:ext cx="3574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**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43" name="Straight Connector 47"/>
            <p:cNvSpPr/>
            <p:nvPr/>
          </p:nvSpPr>
          <p:spPr>
            <a:xfrm>
              <a:off x="2865600" y="3654720"/>
              <a:ext cx="0" cy="237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44" name="Group 54"/>
          <p:cNvGrpSpPr/>
          <p:nvPr/>
        </p:nvGrpSpPr>
        <p:grpSpPr>
          <a:xfrm>
            <a:off x="3900600" y="3381480"/>
            <a:ext cx="2006640" cy="484200"/>
            <a:chOff x="3900600" y="3381480"/>
            <a:chExt cx="2006640" cy="484200"/>
          </a:xfrm>
        </p:grpSpPr>
        <p:grpSp>
          <p:nvGrpSpPr>
            <p:cNvPr id="145" name="Group 55"/>
            <p:cNvGrpSpPr/>
            <p:nvPr/>
          </p:nvGrpSpPr>
          <p:grpSpPr>
            <a:xfrm>
              <a:off x="3900600" y="3381480"/>
              <a:ext cx="2002320" cy="474120"/>
              <a:chOff x="3900600" y="3381480"/>
              <a:chExt cx="2002320" cy="474120"/>
            </a:xfrm>
          </p:grpSpPr>
          <p:sp>
            <p:nvSpPr>
              <p:cNvPr id="146" name="Straight Connector 57"/>
              <p:cNvSpPr/>
              <p:nvPr/>
            </p:nvSpPr>
            <p:spPr>
              <a:xfrm>
                <a:off x="3900600" y="3613680"/>
                <a:ext cx="20023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Straight Connector 58"/>
              <p:cNvSpPr/>
              <p:nvPr/>
            </p:nvSpPr>
            <p:spPr>
              <a:xfrm>
                <a:off x="3911400" y="3616920"/>
                <a:ext cx="0" cy="238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Straight Connector 59"/>
              <p:cNvSpPr/>
              <p:nvPr/>
            </p:nvSpPr>
            <p:spPr>
              <a:xfrm>
                <a:off x="4438800" y="3616920"/>
                <a:ext cx="0" cy="238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Straight Connector 60"/>
              <p:cNvSpPr/>
              <p:nvPr/>
            </p:nvSpPr>
            <p:spPr>
              <a:xfrm>
                <a:off x="4943880" y="3616920"/>
                <a:ext cx="0" cy="238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Straight Connector 61"/>
              <p:cNvSpPr/>
              <p:nvPr/>
            </p:nvSpPr>
            <p:spPr>
              <a:xfrm>
                <a:off x="5447160" y="3616920"/>
                <a:ext cx="0" cy="238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TextBox 62"/>
              <p:cNvSpPr/>
              <p:nvPr/>
            </p:nvSpPr>
            <p:spPr>
              <a:xfrm>
                <a:off x="4695120" y="3381480"/>
                <a:ext cx="3574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**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52" name="Straight Connector 56"/>
            <p:cNvSpPr/>
            <p:nvPr/>
          </p:nvSpPr>
          <p:spPr>
            <a:xfrm>
              <a:off x="5907240" y="3627720"/>
              <a:ext cx="0" cy="237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3" name="Group 2"/>
          <p:cNvGrpSpPr/>
          <p:nvPr/>
        </p:nvGrpSpPr>
        <p:grpSpPr>
          <a:xfrm>
            <a:off x="-34920" y="2606760"/>
            <a:ext cx="9404280" cy="2812680"/>
            <a:chOff x="-34920" y="2606760"/>
            <a:chExt cx="9404280" cy="2812680"/>
          </a:xfrm>
        </p:grpSpPr>
        <p:sp>
          <p:nvSpPr>
            <p:cNvPr id="154" name="文本框 8"/>
            <p:cNvSpPr/>
            <p:nvPr/>
          </p:nvSpPr>
          <p:spPr>
            <a:xfrm>
              <a:off x="7469280" y="5112360"/>
              <a:ext cx="1900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Annexin V-FITC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55" name="Group 2"/>
            <p:cNvGrpSpPr/>
            <p:nvPr/>
          </p:nvGrpSpPr>
          <p:grpSpPr>
            <a:xfrm>
              <a:off x="-34920" y="2606760"/>
              <a:ext cx="9124920" cy="2446200"/>
              <a:chOff x="-34920" y="2606760"/>
              <a:chExt cx="9124920" cy="2446200"/>
            </a:xfrm>
          </p:grpSpPr>
          <p:sp>
            <p:nvSpPr>
              <p:cNvPr id="156" name="文本框 6"/>
              <p:cNvSpPr/>
              <p:nvPr/>
            </p:nvSpPr>
            <p:spPr>
              <a:xfrm>
                <a:off x="523800" y="2790720"/>
                <a:ext cx="2147760" cy="291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300" spc="-1" strike="noStrike">
                    <a:solidFill>
                      <a:srgbClr val="000000"/>
                    </a:solidFill>
                    <a:latin typeface="Arial"/>
                  </a:rPr>
                  <a:t>HEL-24h-apoptosis</a:t>
                </a:r>
                <a:endParaRPr b="0" lang="en-US" sz="1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57" name="组合 90"/>
              <p:cNvGrpSpPr/>
              <p:nvPr/>
            </p:nvGrpSpPr>
            <p:grpSpPr>
              <a:xfrm>
                <a:off x="984600" y="4726800"/>
                <a:ext cx="7890480" cy="286920"/>
                <a:chOff x="984600" y="4726800"/>
                <a:chExt cx="7890480" cy="286920"/>
              </a:xfrm>
            </p:grpSpPr>
            <p:sp>
              <p:nvSpPr>
                <p:cNvPr id="158" name="文本框 1"/>
                <p:cNvSpPr/>
                <p:nvPr/>
              </p:nvSpPr>
              <p:spPr>
                <a:xfrm>
                  <a:off x="7516800" y="4737240"/>
                  <a:ext cx="13582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Cedrelone-5</a:t>
                  </a:r>
                  <a:r>
                    <a:rPr b="1" lang="el-GR" sz="1200" spc="-1" strike="noStrike">
                      <a:solidFill>
                        <a:srgbClr val="000000"/>
                      </a:solidFill>
                      <a:latin typeface="Arial"/>
                    </a:rPr>
                    <a:t>μ</a:t>
                  </a: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M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59" name="组合 93"/>
                <p:cNvGrpSpPr/>
                <p:nvPr/>
              </p:nvGrpSpPr>
              <p:grpSpPr>
                <a:xfrm>
                  <a:off x="984600" y="4726800"/>
                  <a:ext cx="6086880" cy="281160"/>
                  <a:chOff x="984600" y="4726800"/>
                  <a:chExt cx="6086880" cy="281160"/>
                </a:xfrm>
              </p:grpSpPr>
              <p:sp>
                <p:nvSpPr>
                  <p:cNvPr id="160" name="文本框 1"/>
                  <p:cNvSpPr/>
                  <p:nvPr/>
                </p:nvSpPr>
                <p:spPr>
                  <a:xfrm>
                    <a:off x="5922360" y="4728240"/>
                    <a:ext cx="114912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Arial"/>
                      </a:rPr>
                      <a:t>A1543-0.5</a:t>
                    </a:r>
                    <a:r>
                      <a:rPr b="1" lang="el-GR" sz="1200" spc="-1" strike="noStrike">
                        <a:solidFill>
                          <a:srgbClr val="000000"/>
                        </a:solidFill>
                        <a:latin typeface="Arial"/>
                      </a:rPr>
                      <a:t>μ</a:t>
                    </a: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Arial"/>
                      </a:rPr>
                      <a:t>M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161" name="组合 95"/>
                  <p:cNvGrpSpPr/>
                  <p:nvPr/>
                </p:nvGrpSpPr>
                <p:grpSpPr>
                  <a:xfrm>
                    <a:off x="984600" y="4726800"/>
                    <a:ext cx="4701240" cy="281160"/>
                    <a:chOff x="984600" y="4726800"/>
                    <a:chExt cx="4701240" cy="281160"/>
                  </a:xfrm>
                </p:grpSpPr>
                <p:grpSp>
                  <p:nvGrpSpPr>
                    <p:cNvPr id="162" name="组合 96"/>
                    <p:cNvGrpSpPr/>
                    <p:nvPr/>
                  </p:nvGrpSpPr>
                  <p:grpSpPr>
                    <a:xfrm>
                      <a:off x="984600" y="4730040"/>
                      <a:ext cx="2577960" cy="277920"/>
                      <a:chOff x="984600" y="4730040"/>
                      <a:chExt cx="2577960" cy="277920"/>
                    </a:xfrm>
                  </p:grpSpPr>
                  <p:sp>
                    <p:nvSpPr>
                      <p:cNvPr id="163" name="文本框 1"/>
                      <p:cNvSpPr/>
                      <p:nvPr/>
                    </p:nvSpPr>
                    <p:spPr>
                      <a:xfrm>
                        <a:off x="984600" y="4730040"/>
                        <a:ext cx="831960" cy="27648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spAutoFit/>
                      </a:bodyPr>
                      <a:p>
                        <a:pPr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1" lang="en-US" sz="1200" spc="-1" strike="noStrike">
                            <a:solidFill>
                              <a:srgbClr val="000000"/>
                            </a:solidFill>
                            <a:latin typeface="Arial"/>
                          </a:rPr>
                          <a:t>DMSO</a:t>
                        </a:r>
                        <a:endParaRPr b="0" lang="en-US" sz="12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64" name="文本框 1"/>
                      <p:cNvSpPr/>
                      <p:nvPr/>
                    </p:nvSpPr>
                    <p:spPr>
                      <a:xfrm>
                        <a:off x="2425680" y="4731480"/>
                        <a:ext cx="1136880" cy="27648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spAutoFit/>
                      </a:bodyPr>
                      <a:p>
                        <a:pPr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1" lang="en-US" sz="1200" spc="-1" strike="noStrike">
                            <a:solidFill>
                              <a:srgbClr val="000000"/>
                            </a:solidFill>
                            <a:latin typeface="Arial"/>
                          </a:rPr>
                          <a:t>A1541-0.5</a:t>
                        </a:r>
                        <a:r>
                          <a:rPr b="1" lang="el-GR" sz="1200" spc="-1" strike="noStrike">
                            <a:solidFill>
                              <a:srgbClr val="000000"/>
                            </a:solidFill>
                            <a:latin typeface="Arial"/>
                          </a:rPr>
                          <a:t>μ</a:t>
                        </a:r>
                        <a:r>
                          <a:rPr b="1" lang="en-US" sz="1200" spc="-1" strike="noStrike">
                            <a:solidFill>
                              <a:srgbClr val="000000"/>
                            </a:solidFill>
                            <a:latin typeface="Arial"/>
                          </a:rPr>
                          <a:t>M</a:t>
                        </a:r>
                        <a:endParaRPr b="0" lang="en-US" sz="12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</p:grpSp>
                <p:sp>
                  <p:nvSpPr>
                    <p:cNvPr id="165" name="文本框 1"/>
                    <p:cNvSpPr/>
                    <p:nvPr/>
                  </p:nvSpPr>
                  <p:spPr>
                    <a:xfrm>
                      <a:off x="4136400" y="4726800"/>
                      <a:ext cx="154944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1542-0.5</a:t>
                      </a:r>
                      <a:r>
                        <a:rPr b="1" lang="el-G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μ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</p:grpSp>
          </p:grpSp>
          <p:sp>
            <p:nvSpPr>
              <p:cNvPr id="166" name="右箭头 4"/>
              <p:cNvSpPr/>
              <p:nvPr/>
            </p:nvSpPr>
            <p:spPr>
              <a:xfrm flipV="1">
                <a:off x="369720" y="5006520"/>
                <a:ext cx="8720280" cy="45720"/>
              </a:xfrm>
              <a:prstGeom prst="rightArrow">
                <a:avLst>
                  <a:gd name="adj1" fmla="val 50000"/>
                  <a:gd name="adj2" fmla="val 50332"/>
                </a:avLst>
              </a:prstGeom>
              <a:solidFill>
                <a:srgbClr val="000000"/>
              </a:solidFill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上箭头 3"/>
              <p:cNvSpPr/>
              <p:nvPr/>
            </p:nvSpPr>
            <p:spPr>
              <a:xfrm>
                <a:off x="334800" y="2862360"/>
                <a:ext cx="95040" cy="2175120"/>
              </a:xfrm>
              <a:prstGeom prst="upArrow">
                <a:avLst>
                  <a:gd name="adj1" fmla="val 50000"/>
                  <a:gd name="adj2" fmla="val 50117"/>
                </a:avLst>
              </a:prstGeom>
              <a:solidFill>
                <a:srgbClr val="000000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168" name="Picture 9" descr=""/>
              <p:cNvPicPr/>
              <p:nvPr/>
            </p:nvPicPr>
            <p:blipFill>
              <a:blip r:embed="rId1"/>
              <a:stretch/>
            </p:blipFill>
            <p:spPr>
              <a:xfrm>
                <a:off x="-34920" y="2606760"/>
                <a:ext cx="506160" cy="566280"/>
              </a:xfrm>
              <a:prstGeom prst="rect">
                <a:avLst/>
              </a:prstGeom>
              <a:ln w="0">
                <a:noFill/>
              </a:ln>
            </p:spPr>
          </p:pic>
        </p:grpSp>
      </p:grpSp>
      <p:grpSp>
        <p:nvGrpSpPr>
          <p:cNvPr id="169" name="Group 3"/>
          <p:cNvGrpSpPr/>
          <p:nvPr/>
        </p:nvGrpSpPr>
        <p:grpSpPr>
          <a:xfrm>
            <a:off x="-66600" y="87480"/>
            <a:ext cx="9467640" cy="2836080"/>
            <a:chOff x="-66600" y="87480"/>
            <a:chExt cx="9467640" cy="2836080"/>
          </a:xfrm>
        </p:grpSpPr>
        <p:sp>
          <p:nvSpPr>
            <p:cNvPr id="170" name="文本框 6"/>
            <p:cNvSpPr/>
            <p:nvPr/>
          </p:nvSpPr>
          <p:spPr>
            <a:xfrm>
              <a:off x="471240" y="282600"/>
              <a:ext cx="225252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CB7-24h-apoptosis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71" name="组合 26"/>
            <p:cNvGrpSpPr/>
            <p:nvPr/>
          </p:nvGrpSpPr>
          <p:grpSpPr>
            <a:xfrm>
              <a:off x="963360" y="2183400"/>
              <a:ext cx="7921440" cy="314640"/>
              <a:chOff x="963360" y="2183400"/>
              <a:chExt cx="7921440" cy="314640"/>
            </a:xfrm>
          </p:grpSpPr>
          <p:sp>
            <p:nvSpPr>
              <p:cNvPr id="172" name="文本框 1"/>
              <p:cNvSpPr/>
              <p:nvPr/>
            </p:nvSpPr>
            <p:spPr>
              <a:xfrm>
                <a:off x="7500600" y="2210400"/>
                <a:ext cx="13842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edrelone-5</a:t>
                </a:r>
                <a:r>
                  <a:rPr b="1" lang="el-GR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μ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M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73" name="组合 28"/>
              <p:cNvGrpSpPr/>
              <p:nvPr/>
            </p:nvGrpSpPr>
            <p:grpSpPr>
              <a:xfrm>
                <a:off x="963360" y="2183400"/>
                <a:ext cx="6089400" cy="314640"/>
                <a:chOff x="963360" y="2183400"/>
                <a:chExt cx="6089400" cy="314640"/>
              </a:xfrm>
            </p:grpSpPr>
            <p:sp>
              <p:nvSpPr>
                <p:cNvPr id="174" name="文本框 1"/>
                <p:cNvSpPr/>
                <p:nvPr/>
              </p:nvSpPr>
              <p:spPr>
                <a:xfrm>
                  <a:off x="5784120" y="2221560"/>
                  <a:ext cx="12686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A1543-0.5</a:t>
                  </a:r>
                  <a:r>
                    <a:rPr b="1" lang="el-GR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μ</a:t>
                  </a: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M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75" name="组合 30"/>
                <p:cNvGrpSpPr/>
                <p:nvPr/>
              </p:nvGrpSpPr>
              <p:grpSpPr>
                <a:xfrm>
                  <a:off x="963360" y="2183400"/>
                  <a:ext cx="4600080" cy="303480"/>
                  <a:chOff x="963360" y="2183400"/>
                  <a:chExt cx="4600080" cy="303480"/>
                </a:xfrm>
              </p:grpSpPr>
              <p:grpSp>
                <p:nvGrpSpPr>
                  <p:cNvPr id="176" name="组合 31"/>
                  <p:cNvGrpSpPr/>
                  <p:nvPr/>
                </p:nvGrpSpPr>
                <p:grpSpPr>
                  <a:xfrm>
                    <a:off x="963360" y="2183400"/>
                    <a:ext cx="2594160" cy="294120"/>
                    <a:chOff x="963360" y="2183400"/>
                    <a:chExt cx="2594160" cy="294120"/>
                  </a:xfrm>
                </p:grpSpPr>
                <p:sp>
                  <p:nvSpPr>
                    <p:cNvPr id="177" name="文本框 1"/>
                    <p:cNvSpPr/>
                    <p:nvPr/>
                  </p:nvSpPr>
                  <p:spPr>
                    <a:xfrm>
                      <a:off x="963360" y="2201040"/>
                      <a:ext cx="69372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MSO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8" name="文本框 1"/>
                    <p:cNvSpPr/>
                    <p:nvPr/>
                  </p:nvSpPr>
                  <p:spPr>
                    <a:xfrm>
                      <a:off x="2363760" y="2183400"/>
                      <a:ext cx="119376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1541-0.5</a:t>
                      </a:r>
                      <a:r>
                        <a:rPr b="1" lang="el-GR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μ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179" name="文本框 1"/>
                  <p:cNvSpPr/>
                  <p:nvPr/>
                </p:nvSpPr>
                <p:spPr>
                  <a:xfrm>
                    <a:off x="4110120" y="2210400"/>
                    <a:ext cx="145332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A1542-0.5</a:t>
                    </a:r>
                    <a:r>
                      <a:rPr b="1" lang="el-GR" sz="12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μ</a:t>
                    </a: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M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</p:grpSp>
        <p:sp>
          <p:nvSpPr>
            <p:cNvPr id="180" name="文本框 8"/>
            <p:cNvSpPr/>
            <p:nvPr/>
          </p:nvSpPr>
          <p:spPr>
            <a:xfrm>
              <a:off x="7500600" y="2616480"/>
              <a:ext cx="19004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Annexin V-FITC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右箭头 4"/>
            <p:cNvSpPr/>
            <p:nvPr/>
          </p:nvSpPr>
          <p:spPr>
            <a:xfrm flipV="1">
              <a:off x="331560" y="2516760"/>
              <a:ext cx="8719920" cy="45720"/>
            </a:xfrm>
            <a:prstGeom prst="rightArrow">
              <a:avLst>
                <a:gd name="adj1" fmla="val 50000"/>
                <a:gd name="adj2" fmla="val 50330"/>
              </a:avLst>
            </a:prstGeom>
            <a:solidFill>
              <a:srgbClr val="000000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760" bIns="-237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上箭头 3"/>
            <p:cNvSpPr/>
            <p:nvPr/>
          </p:nvSpPr>
          <p:spPr>
            <a:xfrm>
              <a:off x="296640" y="371520"/>
              <a:ext cx="95040" cy="2176560"/>
            </a:xfrm>
            <a:prstGeom prst="upArrow">
              <a:avLst>
                <a:gd name="adj1" fmla="val 50000"/>
                <a:gd name="adj2" fmla="val 50150"/>
              </a:avLst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83" name="Picture 9" descr=""/>
            <p:cNvPicPr/>
            <p:nvPr/>
          </p:nvPicPr>
          <p:blipFill>
            <a:blip r:embed="rId2"/>
            <a:stretch/>
          </p:blipFill>
          <p:spPr>
            <a:xfrm>
              <a:off x="-66600" y="87480"/>
              <a:ext cx="506160" cy="56664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84" name="TextBox 1"/>
          <p:cNvSpPr/>
          <p:nvPr/>
        </p:nvSpPr>
        <p:spPr>
          <a:xfrm>
            <a:off x="317520" y="5510160"/>
            <a:ext cx="855360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l figure 3: Induction of Apoptosis by the compounds in erythroleukemic cells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(A) A1541-43 and Cedrelone treatment increased the percentage of Annexin V-positive apoptotic cells in CB7 cells 24 hours post drug treatment. (B) While A1541-43 compounds failed to increase the percentage of apoptosis in HEL cells, Cedrelone was able to promote cell death in these cell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85" name="图片 4" descr=""/>
          <p:cNvPicPr/>
          <p:nvPr/>
        </p:nvPicPr>
        <p:blipFill>
          <a:blip r:embed="rId3"/>
          <a:stretch/>
        </p:blipFill>
        <p:spPr>
          <a:xfrm>
            <a:off x="430200" y="507960"/>
            <a:ext cx="1638360" cy="1657440"/>
          </a:xfrm>
          <a:prstGeom prst="rect">
            <a:avLst/>
          </a:prstGeom>
          <a:ln w="0">
            <a:noFill/>
          </a:ln>
        </p:spPr>
      </p:pic>
      <p:pic>
        <p:nvPicPr>
          <p:cNvPr id="186" name="图片 5" descr=""/>
          <p:cNvPicPr/>
          <p:nvPr/>
        </p:nvPicPr>
        <p:blipFill>
          <a:blip r:embed="rId4"/>
          <a:stretch/>
        </p:blipFill>
        <p:spPr>
          <a:xfrm>
            <a:off x="2106720" y="507960"/>
            <a:ext cx="1638360" cy="1657440"/>
          </a:xfrm>
          <a:prstGeom prst="rect">
            <a:avLst/>
          </a:prstGeom>
          <a:ln w="0">
            <a:noFill/>
          </a:ln>
        </p:spPr>
      </p:pic>
      <p:pic>
        <p:nvPicPr>
          <p:cNvPr id="187" name="图片 6" descr=""/>
          <p:cNvPicPr/>
          <p:nvPr/>
        </p:nvPicPr>
        <p:blipFill>
          <a:blip r:embed="rId5"/>
          <a:stretch/>
        </p:blipFill>
        <p:spPr>
          <a:xfrm>
            <a:off x="3782880" y="507960"/>
            <a:ext cx="1636920" cy="1657440"/>
          </a:xfrm>
          <a:prstGeom prst="rect">
            <a:avLst/>
          </a:prstGeom>
          <a:ln w="0">
            <a:noFill/>
          </a:ln>
        </p:spPr>
      </p:pic>
      <p:pic>
        <p:nvPicPr>
          <p:cNvPr id="188" name="图片 7" descr=""/>
          <p:cNvPicPr/>
          <p:nvPr/>
        </p:nvPicPr>
        <p:blipFill>
          <a:blip r:embed="rId6"/>
          <a:stretch/>
        </p:blipFill>
        <p:spPr>
          <a:xfrm>
            <a:off x="5494320" y="507960"/>
            <a:ext cx="1638360" cy="1657440"/>
          </a:xfrm>
          <a:prstGeom prst="rect">
            <a:avLst/>
          </a:prstGeom>
          <a:ln w="0">
            <a:noFill/>
          </a:ln>
        </p:spPr>
      </p:pic>
      <p:pic>
        <p:nvPicPr>
          <p:cNvPr id="189" name="图片 8" descr=""/>
          <p:cNvPicPr/>
          <p:nvPr/>
        </p:nvPicPr>
        <p:blipFill>
          <a:blip r:embed="rId7"/>
          <a:stretch/>
        </p:blipFill>
        <p:spPr>
          <a:xfrm>
            <a:off x="7232760" y="507960"/>
            <a:ext cx="1638360" cy="1657440"/>
          </a:xfrm>
          <a:prstGeom prst="rect">
            <a:avLst/>
          </a:prstGeom>
          <a:ln w="0">
            <a:noFill/>
          </a:ln>
        </p:spPr>
      </p:pic>
      <p:pic>
        <p:nvPicPr>
          <p:cNvPr id="190" name="图片 9" descr=""/>
          <p:cNvPicPr/>
          <p:nvPr/>
        </p:nvPicPr>
        <p:blipFill>
          <a:blip r:embed="rId8"/>
          <a:stretch/>
        </p:blipFill>
        <p:spPr>
          <a:xfrm>
            <a:off x="468360" y="3079800"/>
            <a:ext cx="1638360" cy="1657440"/>
          </a:xfrm>
          <a:prstGeom prst="rect">
            <a:avLst/>
          </a:prstGeom>
          <a:ln w="0">
            <a:noFill/>
          </a:ln>
        </p:spPr>
      </p:pic>
      <p:pic>
        <p:nvPicPr>
          <p:cNvPr id="191" name="图片 10" descr=""/>
          <p:cNvPicPr/>
          <p:nvPr/>
        </p:nvPicPr>
        <p:blipFill>
          <a:blip r:embed="rId9"/>
          <a:stretch/>
        </p:blipFill>
        <p:spPr>
          <a:xfrm>
            <a:off x="2144880" y="3079800"/>
            <a:ext cx="1638000" cy="1657440"/>
          </a:xfrm>
          <a:prstGeom prst="rect">
            <a:avLst/>
          </a:prstGeom>
          <a:ln w="0">
            <a:noFill/>
          </a:ln>
        </p:spPr>
      </p:pic>
      <p:pic>
        <p:nvPicPr>
          <p:cNvPr id="192" name="图片 11" descr=""/>
          <p:cNvPicPr/>
          <p:nvPr/>
        </p:nvPicPr>
        <p:blipFill>
          <a:blip r:embed="rId10"/>
          <a:stretch/>
        </p:blipFill>
        <p:spPr>
          <a:xfrm>
            <a:off x="3855960" y="3059280"/>
            <a:ext cx="1638360" cy="1657080"/>
          </a:xfrm>
          <a:prstGeom prst="rect">
            <a:avLst/>
          </a:prstGeom>
          <a:ln w="0">
            <a:noFill/>
          </a:ln>
        </p:spPr>
      </p:pic>
      <p:pic>
        <p:nvPicPr>
          <p:cNvPr id="193" name="图片 12" descr=""/>
          <p:cNvPicPr/>
          <p:nvPr/>
        </p:nvPicPr>
        <p:blipFill>
          <a:blip r:embed="rId11"/>
          <a:stretch/>
        </p:blipFill>
        <p:spPr>
          <a:xfrm>
            <a:off x="5594400" y="3073320"/>
            <a:ext cx="1638360" cy="1656000"/>
          </a:xfrm>
          <a:prstGeom prst="rect">
            <a:avLst/>
          </a:prstGeom>
          <a:ln w="0">
            <a:noFill/>
          </a:ln>
        </p:spPr>
      </p:pic>
      <p:pic>
        <p:nvPicPr>
          <p:cNvPr id="194" name="图片 13" descr=""/>
          <p:cNvPicPr/>
          <p:nvPr/>
        </p:nvPicPr>
        <p:blipFill>
          <a:blip r:embed="rId12"/>
          <a:stretch/>
        </p:blipFill>
        <p:spPr>
          <a:xfrm>
            <a:off x="7232760" y="3073320"/>
            <a:ext cx="1638360" cy="1656000"/>
          </a:xfrm>
          <a:prstGeom prst="rect">
            <a:avLst/>
          </a:prstGeom>
          <a:ln w="0">
            <a:noFill/>
          </a:ln>
        </p:spPr>
      </p:pic>
      <p:sp>
        <p:nvSpPr>
          <p:cNvPr id="195" name="TextBox 2"/>
          <p:cNvSpPr/>
          <p:nvPr/>
        </p:nvSpPr>
        <p:spPr>
          <a:xfrm>
            <a:off x="456840" y="111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TextBox 44"/>
          <p:cNvSpPr/>
          <p:nvPr/>
        </p:nvSpPr>
        <p:spPr>
          <a:xfrm>
            <a:off x="513000" y="253224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TextBox 45"/>
          <p:cNvSpPr/>
          <p:nvPr/>
        </p:nvSpPr>
        <p:spPr>
          <a:xfrm rot="16200000">
            <a:off x="-39960" y="1216440"/>
            <a:ext cx="45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L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TextBox 46"/>
          <p:cNvSpPr/>
          <p:nvPr/>
        </p:nvSpPr>
        <p:spPr>
          <a:xfrm rot="16200000">
            <a:off x="-8280" y="3683520"/>
            <a:ext cx="45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L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9" name="Group 3"/>
          <p:cNvGrpSpPr/>
          <p:nvPr/>
        </p:nvGrpSpPr>
        <p:grpSpPr>
          <a:xfrm>
            <a:off x="11160" y="3173400"/>
            <a:ext cx="9078840" cy="2571840"/>
            <a:chOff x="11160" y="3173400"/>
            <a:chExt cx="9078840" cy="2571840"/>
          </a:xfrm>
        </p:grpSpPr>
        <p:sp>
          <p:nvSpPr>
            <p:cNvPr id="200" name="文本框 6"/>
            <p:cNvSpPr/>
            <p:nvPr/>
          </p:nvSpPr>
          <p:spPr>
            <a:xfrm>
              <a:off x="406440" y="3173400"/>
              <a:ext cx="185256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</a:rPr>
                <a:t>HEL-24h-Cell cycle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01" name="组合 7"/>
            <p:cNvGrpSpPr/>
            <p:nvPr/>
          </p:nvGrpSpPr>
          <p:grpSpPr>
            <a:xfrm>
              <a:off x="492480" y="3599640"/>
              <a:ext cx="8597520" cy="1950840"/>
              <a:chOff x="492480" y="3599640"/>
              <a:chExt cx="8597520" cy="1950840"/>
            </a:xfrm>
          </p:grpSpPr>
          <p:grpSp>
            <p:nvGrpSpPr>
              <p:cNvPr id="202" name="组合 25"/>
              <p:cNvGrpSpPr/>
              <p:nvPr/>
            </p:nvGrpSpPr>
            <p:grpSpPr>
              <a:xfrm>
                <a:off x="977400" y="5213520"/>
                <a:ext cx="8105760" cy="336960"/>
                <a:chOff x="977400" y="5213520"/>
                <a:chExt cx="8105760" cy="336960"/>
              </a:xfrm>
            </p:grpSpPr>
            <p:sp>
              <p:nvSpPr>
                <p:cNvPr id="203" name="文本框 1"/>
                <p:cNvSpPr/>
                <p:nvPr/>
              </p:nvSpPr>
              <p:spPr>
                <a:xfrm>
                  <a:off x="7540200" y="5229720"/>
                  <a:ext cx="15429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Cedrelone-5</a:t>
                  </a:r>
                  <a:r>
                    <a:rPr b="1" lang="el-GR" sz="1200" spc="-1" strike="noStrike">
                      <a:solidFill>
                        <a:srgbClr val="000000"/>
                      </a:solidFill>
                      <a:latin typeface="Arial"/>
                    </a:rPr>
                    <a:t>μ</a:t>
                  </a: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M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204" name="组合 24"/>
                <p:cNvGrpSpPr/>
                <p:nvPr/>
              </p:nvGrpSpPr>
              <p:grpSpPr>
                <a:xfrm>
                  <a:off x="977400" y="5213520"/>
                  <a:ext cx="6189840" cy="336960"/>
                  <a:chOff x="977400" y="5213520"/>
                  <a:chExt cx="6189840" cy="336960"/>
                </a:xfrm>
              </p:grpSpPr>
              <p:sp>
                <p:nvSpPr>
                  <p:cNvPr id="205" name="文本框 1"/>
                  <p:cNvSpPr/>
                  <p:nvPr/>
                </p:nvSpPr>
                <p:spPr>
                  <a:xfrm>
                    <a:off x="6023160" y="5244120"/>
                    <a:ext cx="114408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Arial"/>
                      </a:rPr>
                      <a:t>A1543-0.5</a:t>
                    </a:r>
                    <a:r>
                      <a:rPr b="1" lang="el-GR" sz="1200" spc="-1" strike="noStrike">
                        <a:solidFill>
                          <a:srgbClr val="000000"/>
                        </a:solidFill>
                        <a:latin typeface="Arial"/>
                      </a:rPr>
                      <a:t>μ</a:t>
                    </a: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Arial"/>
                      </a:rPr>
                      <a:t>M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206" name="组合 23"/>
                  <p:cNvGrpSpPr/>
                  <p:nvPr/>
                </p:nvGrpSpPr>
                <p:grpSpPr>
                  <a:xfrm>
                    <a:off x="977400" y="5213520"/>
                    <a:ext cx="4547160" cy="336960"/>
                    <a:chOff x="977400" y="5213520"/>
                    <a:chExt cx="4547160" cy="336960"/>
                  </a:xfrm>
                </p:grpSpPr>
                <p:grpSp>
                  <p:nvGrpSpPr>
                    <p:cNvPr id="207" name="组合 2"/>
                    <p:cNvGrpSpPr/>
                    <p:nvPr/>
                  </p:nvGrpSpPr>
                  <p:grpSpPr>
                    <a:xfrm>
                      <a:off x="977400" y="5213520"/>
                      <a:ext cx="2835000" cy="336960"/>
                      <a:chOff x="977400" y="5213520"/>
                      <a:chExt cx="2835000" cy="336960"/>
                    </a:xfrm>
                  </p:grpSpPr>
                  <p:sp>
                    <p:nvSpPr>
                      <p:cNvPr id="208" name="文本框 1"/>
                      <p:cNvSpPr/>
                      <p:nvPr/>
                    </p:nvSpPr>
                    <p:spPr>
                      <a:xfrm>
                        <a:off x="977400" y="5213520"/>
                        <a:ext cx="726480" cy="27648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spAutoFit/>
                      </a:bodyPr>
                      <a:p>
                        <a:pPr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1" lang="en-US" sz="1200" spc="-1" strike="noStrike">
                            <a:solidFill>
                              <a:srgbClr val="000000"/>
                            </a:solidFill>
                            <a:latin typeface="Arial"/>
                          </a:rPr>
                          <a:t>DMSO</a:t>
                        </a:r>
                        <a:endParaRPr b="0" lang="en-US" sz="12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209" name="文本框 1"/>
                      <p:cNvSpPr/>
                      <p:nvPr/>
                    </p:nvSpPr>
                    <p:spPr>
                      <a:xfrm>
                        <a:off x="2585520" y="5274000"/>
                        <a:ext cx="1226880" cy="27648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spAutoFit/>
                      </a:bodyPr>
                      <a:p>
                        <a:pPr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1" lang="en-US" sz="1200" spc="-1" strike="noStrike">
                            <a:solidFill>
                              <a:srgbClr val="000000"/>
                            </a:solidFill>
                            <a:latin typeface="Arial"/>
                          </a:rPr>
                          <a:t>A1541-0.5</a:t>
                        </a:r>
                        <a:r>
                          <a:rPr b="1" lang="el-GR" sz="1200" spc="-1" strike="noStrike">
                            <a:solidFill>
                              <a:srgbClr val="000000"/>
                            </a:solidFill>
                            <a:latin typeface="Arial"/>
                          </a:rPr>
                          <a:t>μ</a:t>
                        </a:r>
                        <a:r>
                          <a:rPr b="1" lang="en-US" sz="1200" spc="-1" strike="noStrike">
                            <a:solidFill>
                              <a:srgbClr val="000000"/>
                            </a:solidFill>
                            <a:latin typeface="Arial"/>
                          </a:rPr>
                          <a:t>M</a:t>
                        </a:r>
                        <a:endParaRPr b="0" lang="en-US" sz="12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</p:grpSp>
                <p:sp>
                  <p:nvSpPr>
                    <p:cNvPr id="210" name="文本框 1"/>
                    <p:cNvSpPr/>
                    <p:nvPr/>
                  </p:nvSpPr>
                  <p:spPr>
                    <a:xfrm>
                      <a:off x="4223520" y="5247360"/>
                      <a:ext cx="130104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1542-0.5</a:t>
                      </a:r>
                      <a:r>
                        <a:rPr b="1" lang="el-G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μ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</p:grpSp>
          </p:grpSp>
          <p:grpSp>
            <p:nvGrpSpPr>
              <p:cNvPr id="211" name="组合 6"/>
              <p:cNvGrpSpPr/>
              <p:nvPr/>
            </p:nvGrpSpPr>
            <p:grpSpPr>
              <a:xfrm>
                <a:off x="492480" y="3599640"/>
                <a:ext cx="8597520" cy="1665720"/>
                <a:chOff x="492480" y="3599640"/>
                <a:chExt cx="8597520" cy="1665720"/>
              </a:xfrm>
            </p:grpSpPr>
            <p:grpSp>
              <p:nvGrpSpPr>
                <p:cNvPr id="212" name="组合 5"/>
                <p:cNvGrpSpPr/>
                <p:nvPr/>
              </p:nvGrpSpPr>
              <p:grpSpPr>
                <a:xfrm>
                  <a:off x="492480" y="3599640"/>
                  <a:ext cx="6763680" cy="1665720"/>
                  <a:chOff x="492480" y="3599640"/>
                  <a:chExt cx="6763680" cy="1665720"/>
                </a:xfrm>
              </p:grpSpPr>
              <p:grpSp>
                <p:nvGrpSpPr>
                  <p:cNvPr id="213" name="组合 4"/>
                  <p:cNvGrpSpPr/>
                  <p:nvPr/>
                </p:nvGrpSpPr>
                <p:grpSpPr>
                  <a:xfrm>
                    <a:off x="492480" y="3599640"/>
                    <a:ext cx="5092200" cy="1665720"/>
                    <a:chOff x="492480" y="3599640"/>
                    <a:chExt cx="5092200" cy="1665720"/>
                  </a:xfrm>
                </p:grpSpPr>
                <p:grpSp>
                  <p:nvGrpSpPr>
                    <p:cNvPr id="214" name="组合 3"/>
                    <p:cNvGrpSpPr/>
                    <p:nvPr/>
                  </p:nvGrpSpPr>
                  <p:grpSpPr>
                    <a:xfrm>
                      <a:off x="492480" y="3599640"/>
                      <a:ext cx="3391920" cy="1665720"/>
                      <a:chOff x="492480" y="3599640"/>
                      <a:chExt cx="3391920" cy="1665720"/>
                    </a:xfrm>
                  </p:grpSpPr>
                  <p:grpSp>
                    <p:nvGrpSpPr>
                      <p:cNvPr id="215" name="组合 35"/>
                      <p:cNvGrpSpPr/>
                      <p:nvPr/>
                    </p:nvGrpSpPr>
                    <p:grpSpPr>
                      <a:xfrm>
                        <a:off x="492480" y="3599640"/>
                        <a:ext cx="1674360" cy="1665720"/>
                        <a:chOff x="492480" y="3599640"/>
                        <a:chExt cx="1674360" cy="1665720"/>
                      </a:xfrm>
                    </p:grpSpPr>
                    <p:pic>
                      <p:nvPicPr>
                        <p:cNvPr id="216" name="图片 36" descr=""/>
                        <p:cNvPicPr/>
                        <p:nvPr/>
                      </p:nvPicPr>
                      <p:blipFill>
                        <a:blip r:embed="rId1"/>
                        <a:stretch/>
                      </p:blipFill>
                      <p:spPr>
                        <a:xfrm>
                          <a:off x="492480" y="3599640"/>
                          <a:ext cx="1647360" cy="166572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  <p:sp>
                      <p:nvSpPr>
                        <p:cNvPr id="217" name="文本框 39"/>
                        <p:cNvSpPr/>
                        <p:nvPr/>
                      </p:nvSpPr>
                      <p:spPr>
                        <a:xfrm>
                          <a:off x="1343160" y="3824640"/>
                          <a:ext cx="823680" cy="505440"/>
                        </a:xfrm>
                        <a:prstGeom prst="rect">
                          <a:avLst/>
                        </a:prstGeom>
                        <a:noFill/>
                        <a:ln w="0">
                          <a:noFill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46800" bIns="46800" anchor="t">
                          <a:spAutoFit/>
                        </a:bodyPr>
                        <a:p>
                          <a:pPr>
                            <a:tabLst>
                              <a:tab algn="l" pos="0"/>
                              <a:tab algn="l" pos="914400"/>
                              <a:tab algn="l" pos="1828800"/>
                              <a:tab algn="l" pos="2743200"/>
                              <a:tab algn="l" pos="3657600"/>
                              <a:tab algn="l" pos="4572000"/>
                              <a:tab algn="l" pos="5486400"/>
                              <a:tab algn="l" pos="6400800"/>
                              <a:tab algn="l" pos="7315200"/>
                              <a:tab algn="l" pos="8229600"/>
                              <a:tab algn="l" pos="9144000"/>
                              <a:tab algn="l" pos="10058400"/>
                            </a:tabLst>
                          </a:pPr>
                          <a:r>
                            <a:rPr b="1" lang="en-US" sz="900" spc="-1" strike="noStrike">
                              <a:solidFill>
                                <a:srgbClr val="000000"/>
                              </a:solidFill>
                              <a:latin typeface="Arial"/>
                              <a:ea typeface="Arial"/>
                            </a:rPr>
                            <a:t>G1:37.79%</a:t>
                          </a:r>
                          <a:endParaRPr b="0" lang="en-US" sz="900" spc="-1" strike="noStrike">
                            <a:solidFill>
                              <a:srgbClr val="000000"/>
                            </a:solidFill>
                            <a:latin typeface="Arial"/>
                          </a:endParaRPr>
                        </a:p>
                        <a:p>
                          <a:pPr>
                            <a:tabLst>
                              <a:tab algn="l" pos="0"/>
                              <a:tab algn="l" pos="914400"/>
                              <a:tab algn="l" pos="1828800"/>
                              <a:tab algn="l" pos="2743200"/>
                              <a:tab algn="l" pos="3657600"/>
                              <a:tab algn="l" pos="4572000"/>
                              <a:tab algn="l" pos="5486400"/>
                              <a:tab algn="l" pos="6400800"/>
                              <a:tab algn="l" pos="7315200"/>
                              <a:tab algn="l" pos="8229600"/>
                              <a:tab algn="l" pos="9144000"/>
                              <a:tab algn="l" pos="10058400"/>
                            </a:tabLst>
                          </a:pPr>
                          <a:r>
                            <a:rPr b="1" lang="en-US" sz="900" spc="-1" strike="noStrike">
                              <a:solidFill>
                                <a:srgbClr val="000000"/>
                              </a:solidFill>
                              <a:latin typeface="Arial"/>
                              <a:ea typeface="Arial"/>
                            </a:rPr>
                            <a:t>S:44.55%</a:t>
                          </a:r>
                          <a:endParaRPr b="0" lang="en-US" sz="900" spc="-1" strike="noStrike">
                            <a:solidFill>
                              <a:srgbClr val="000000"/>
                            </a:solidFill>
                            <a:latin typeface="Arial"/>
                          </a:endParaRPr>
                        </a:p>
                        <a:p>
                          <a:pPr>
                            <a:tabLst>
                              <a:tab algn="l" pos="0"/>
                              <a:tab algn="l" pos="914400"/>
                              <a:tab algn="l" pos="1828800"/>
                              <a:tab algn="l" pos="2743200"/>
                              <a:tab algn="l" pos="3657600"/>
                              <a:tab algn="l" pos="4572000"/>
                              <a:tab algn="l" pos="5486400"/>
                              <a:tab algn="l" pos="6400800"/>
                              <a:tab algn="l" pos="7315200"/>
                              <a:tab algn="l" pos="8229600"/>
                              <a:tab algn="l" pos="9144000"/>
                              <a:tab algn="l" pos="10058400"/>
                            </a:tabLst>
                          </a:pPr>
                          <a:r>
                            <a:rPr b="1" lang="en-US" sz="900" spc="-1" strike="noStrike">
                              <a:solidFill>
                                <a:srgbClr val="000000"/>
                              </a:solidFill>
                              <a:latin typeface="Arial"/>
                              <a:ea typeface="Arial"/>
                            </a:rPr>
                            <a:t>G2:17.41%</a:t>
                          </a:r>
                          <a:endParaRPr b="0" lang="en-US" sz="900" spc="-1" strike="noStrike">
                            <a:solidFill>
                              <a:srgbClr val="000000"/>
                            </a:solidFill>
                            <a:latin typeface="Arial"/>
                          </a:endParaRPr>
                        </a:p>
                      </p:txBody>
                    </p:sp>
                  </p:grpSp>
                  <p:grpSp>
                    <p:nvGrpSpPr>
                      <p:cNvPr id="218" name="组合 41"/>
                      <p:cNvGrpSpPr/>
                      <p:nvPr/>
                    </p:nvGrpSpPr>
                    <p:grpSpPr>
                      <a:xfrm>
                        <a:off x="2183400" y="3599640"/>
                        <a:ext cx="1701000" cy="1665720"/>
                        <a:chOff x="2183400" y="3599640"/>
                        <a:chExt cx="1701000" cy="1665720"/>
                      </a:xfrm>
                    </p:grpSpPr>
                    <p:pic>
                      <p:nvPicPr>
                        <p:cNvPr id="219" name="图片 42" descr=""/>
                        <p:cNvPicPr/>
                        <p:nvPr/>
                      </p:nvPicPr>
                      <p:blipFill>
                        <a:blip r:embed="rId2"/>
                        <a:stretch/>
                      </p:blipFill>
                      <p:spPr>
                        <a:xfrm>
                          <a:off x="2183400" y="3599640"/>
                          <a:ext cx="1647000" cy="166572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  <p:sp>
                      <p:nvSpPr>
                        <p:cNvPr id="220" name="文本框 43"/>
                        <p:cNvSpPr/>
                        <p:nvPr/>
                      </p:nvSpPr>
                      <p:spPr>
                        <a:xfrm>
                          <a:off x="3054240" y="3868200"/>
                          <a:ext cx="830160" cy="505440"/>
                        </a:xfrm>
                        <a:prstGeom prst="rect">
                          <a:avLst/>
                        </a:prstGeom>
                        <a:noFill/>
                        <a:ln w="0">
                          <a:noFill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46800" bIns="46800" anchor="t">
                          <a:spAutoFit/>
                        </a:bodyPr>
                        <a:p>
                          <a:pPr>
                            <a:tabLst>
                              <a:tab algn="l" pos="0"/>
                              <a:tab algn="l" pos="914400"/>
                              <a:tab algn="l" pos="1828800"/>
                              <a:tab algn="l" pos="2743200"/>
                              <a:tab algn="l" pos="3657600"/>
                              <a:tab algn="l" pos="4572000"/>
                              <a:tab algn="l" pos="5486400"/>
                              <a:tab algn="l" pos="6400800"/>
                              <a:tab algn="l" pos="7315200"/>
                              <a:tab algn="l" pos="8229600"/>
                              <a:tab algn="l" pos="9144000"/>
                              <a:tab algn="l" pos="10058400"/>
                            </a:tabLst>
                          </a:pPr>
                          <a:r>
                            <a:rPr b="1" lang="en-US" sz="900" spc="-1" strike="noStrike">
                              <a:solidFill>
                                <a:srgbClr val="000000"/>
                              </a:solidFill>
                              <a:latin typeface="Arial"/>
                              <a:ea typeface="Arial"/>
                            </a:rPr>
                            <a:t>G1:13.75%</a:t>
                          </a:r>
                          <a:endParaRPr b="0" lang="en-US" sz="900" spc="-1" strike="noStrike">
                            <a:solidFill>
                              <a:srgbClr val="000000"/>
                            </a:solidFill>
                            <a:latin typeface="Arial"/>
                          </a:endParaRPr>
                        </a:p>
                        <a:p>
                          <a:pPr>
                            <a:tabLst>
                              <a:tab algn="l" pos="0"/>
                              <a:tab algn="l" pos="914400"/>
                              <a:tab algn="l" pos="1828800"/>
                              <a:tab algn="l" pos="2743200"/>
                              <a:tab algn="l" pos="3657600"/>
                              <a:tab algn="l" pos="4572000"/>
                              <a:tab algn="l" pos="5486400"/>
                              <a:tab algn="l" pos="6400800"/>
                              <a:tab algn="l" pos="7315200"/>
                              <a:tab algn="l" pos="8229600"/>
                              <a:tab algn="l" pos="9144000"/>
                              <a:tab algn="l" pos="10058400"/>
                            </a:tabLst>
                          </a:pPr>
                          <a:r>
                            <a:rPr b="1" lang="en-US" sz="900" spc="-1" strike="noStrike">
                              <a:solidFill>
                                <a:srgbClr val="000000"/>
                              </a:solidFill>
                              <a:latin typeface="Arial"/>
                              <a:ea typeface="Arial"/>
                            </a:rPr>
                            <a:t>S:69.06%</a:t>
                          </a:r>
                          <a:endParaRPr b="0" lang="en-US" sz="900" spc="-1" strike="noStrike">
                            <a:solidFill>
                              <a:srgbClr val="000000"/>
                            </a:solidFill>
                            <a:latin typeface="Arial"/>
                          </a:endParaRPr>
                        </a:p>
                        <a:p>
                          <a:pPr>
                            <a:tabLst>
                              <a:tab algn="l" pos="0"/>
                              <a:tab algn="l" pos="914400"/>
                              <a:tab algn="l" pos="1828800"/>
                              <a:tab algn="l" pos="2743200"/>
                              <a:tab algn="l" pos="3657600"/>
                              <a:tab algn="l" pos="4572000"/>
                              <a:tab algn="l" pos="5486400"/>
                              <a:tab algn="l" pos="6400800"/>
                              <a:tab algn="l" pos="7315200"/>
                              <a:tab algn="l" pos="8229600"/>
                              <a:tab algn="l" pos="9144000"/>
                              <a:tab algn="l" pos="10058400"/>
                            </a:tabLst>
                          </a:pPr>
                          <a:r>
                            <a:rPr b="1" lang="en-US" sz="900" spc="-1" strike="noStrike">
                              <a:solidFill>
                                <a:srgbClr val="000000"/>
                              </a:solidFill>
                              <a:latin typeface="Arial"/>
                              <a:ea typeface="Arial"/>
                            </a:rPr>
                            <a:t>G2:16.18%</a:t>
                          </a:r>
                          <a:endParaRPr b="0" lang="en-US" sz="900" spc="-1" strike="noStrike">
                            <a:solidFill>
                              <a:srgbClr val="000000"/>
                            </a:solidFill>
                            <a:latin typeface="Arial"/>
                          </a:endParaRPr>
                        </a:p>
                      </p:txBody>
                    </p:sp>
                  </p:grpSp>
                </p:grpSp>
                <p:grpSp>
                  <p:nvGrpSpPr>
                    <p:cNvPr id="221" name="组合 47"/>
                    <p:cNvGrpSpPr/>
                    <p:nvPr/>
                  </p:nvGrpSpPr>
                  <p:grpSpPr>
                    <a:xfrm>
                      <a:off x="3869640" y="3599640"/>
                      <a:ext cx="1715040" cy="1665720"/>
                      <a:chOff x="3869640" y="3599640"/>
                      <a:chExt cx="1715040" cy="1665720"/>
                    </a:xfrm>
                  </p:grpSpPr>
                  <p:pic>
                    <p:nvPicPr>
                      <p:cNvPr id="222" name="图片 48" descr=""/>
                      <p:cNvPicPr/>
                      <p:nvPr/>
                    </p:nvPicPr>
                    <p:blipFill>
                      <a:blip r:embed="rId3"/>
                      <a:stretch/>
                    </p:blipFill>
                    <p:spPr>
                      <a:xfrm>
                        <a:off x="3869640" y="3599640"/>
                        <a:ext cx="1668960" cy="166572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  <p:sp>
                    <p:nvSpPr>
                      <p:cNvPr id="223" name="文本框 49"/>
                      <p:cNvSpPr/>
                      <p:nvPr/>
                    </p:nvSpPr>
                    <p:spPr>
                      <a:xfrm>
                        <a:off x="4734000" y="3872520"/>
                        <a:ext cx="850680" cy="50544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spAutoFit/>
                      </a:bodyPr>
                      <a:p>
                        <a:pPr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1" lang="en-US" sz="900" spc="-1" strike="noStrike">
                            <a:solidFill>
                              <a:srgbClr val="000000"/>
                            </a:solidFill>
                            <a:latin typeface="Arial"/>
                            <a:ea typeface="Arial"/>
                          </a:rPr>
                          <a:t>G1:18.24%</a:t>
                        </a:r>
                        <a:endParaRPr b="0" lang="en-US" sz="9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  <a:p>
                        <a:pPr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1" lang="en-US" sz="900" spc="-1" strike="noStrike">
                            <a:solidFill>
                              <a:srgbClr val="000000"/>
                            </a:solidFill>
                            <a:latin typeface="Arial"/>
                            <a:ea typeface="Arial"/>
                          </a:rPr>
                          <a:t>S:68.02%</a:t>
                        </a:r>
                        <a:endParaRPr b="0" lang="en-US" sz="9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  <a:p>
                        <a:pPr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1" lang="en-US" sz="900" spc="-1" strike="noStrike">
                            <a:solidFill>
                              <a:srgbClr val="000000"/>
                            </a:solidFill>
                            <a:latin typeface="Arial"/>
                            <a:ea typeface="Arial"/>
                          </a:rPr>
                          <a:t>G2:12.47%</a:t>
                        </a:r>
                        <a:endParaRPr b="0" lang="en-US" sz="9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</p:grpSp>
              </p:grpSp>
              <p:grpSp>
                <p:nvGrpSpPr>
                  <p:cNvPr id="224" name="组合 50"/>
                  <p:cNvGrpSpPr/>
                  <p:nvPr/>
                </p:nvGrpSpPr>
                <p:grpSpPr>
                  <a:xfrm>
                    <a:off x="5556240" y="3599640"/>
                    <a:ext cx="1699920" cy="1665720"/>
                    <a:chOff x="5556240" y="3599640"/>
                    <a:chExt cx="1699920" cy="1665720"/>
                  </a:xfrm>
                </p:grpSpPr>
                <p:pic>
                  <p:nvPicPr>
                    <p:cNvPr id="225" name="图片 51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5556240" y="3599640"/>
                      <a:ext cx="1668600" cy="16657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sp>
                  <p:nvSpPr>
                    <p:cNvPr id="226" name="文本框 52"/>
                    <p:cNvSpPr/>
                    <p:nvPr/>
                  </p:nvSpPr>
                  <p:spPr>
                    <a:xfrm>
                      <a:off x="6401520" y="3824640"/>
                      <a:ext cx="854640" cy="5054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1:16.81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:68.49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2:13.31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</p:grpSp>
            <p:grpSp>
              <p:nvGrpSpPr>
                <p:cNvPr id="227" name="组合 53"/>
                <p:cNvGrpSpPr/>
                <p:nvPr/>
              </p:nvGrpSpPr>
              <p:grpSpPr>
                <a:xfrm>
                  <a:off x="7273800" y="3599640"/>
                  <a:ext cx="1816200" cy="1665720"/>
                  <a:chOff x="7273800" y="3599640"/>
                  <a:chExt cx="1816200" cy="1665720"/>
                </a:xfrm>
              </p:grpSpPr>
              <p:pic>
                <p:nvPicPr>
                  <p:cNvPr id="228" name="图片 54" descr=""/>
                  <p:cNvPicPr/>
                  <p:nvPr/>
                </p:nvPicPr>
                <p:blipFill>
                  <a:blip r:embed="rId5"/>
                  <a:stretch/>
                </p:blipFill>
                <p:spPr>
                  <a:xfrm>
                    <a:off x="7273800" y="3599640"/>
                    <a:ext cx="1646640" cy="1665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229" name="文本框 55"/>
                  <p:cNvSpPr/>
                  <p:nvPr/>
                </p:nvSpPr>
                <p:spPr>
                  <a:xfrm>
                    <a:off x="8239680" y="3833280"/>
                    <a:ext cx="850320" cy="5054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9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G1:26.98%</a:t>
                    </a:r>
                    <a:endParaRPr b="0" lang="en-US" sz="9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9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S:33.62%</a:t>
                    </a:r>
                    <a:endParaRPr b="0" lang="en-US" sz="9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9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G2:40.34%</a:t>
                    </a:r>
                    <a:endParaRPr b="0" lang="en-US" sz="9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</p:grpSp>
        <p:sp>
          <p:nvSpPr>
            <p:cNvPr id="230" name="上箭头 5"/>
            <p:cNvSpPr/>
            <p:nvPr/>
          </p:nvSpPr>
          <p:spPr>
            <a:xfrm>
              <a:off x="363240" y="3184200"/>
              <a:ext cx="56880" cy="2561040"/>
            </a:xfrm>
            <a:prstGeom prst="upArrow">
              <a:avLst>
                <a:gd name="adj1" fmla="val 50000"/>
                <a:gd name="adj2" fmla="val 50237"/>
              </a:avLst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TextBox 9"/>
            <p:cNvSpPr/>
            <p:nvPr/>
          </p:nvSpPr>
          <p:spPr>
            <a:xfrm rot="16200000">
              <a:off x="-369720" y="4143960"/>
              <a:ext cx="1038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No. of cells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32" name="文本框 6"/>
          <p:cNvSpPr/>
          <p:nvPr/>
        </p:nvSpPr>
        <p:spPr>
          <a:xfrm>
            <a:off x="412920" y="260280"/>
            <a:ext cx="17398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</a:rPr>
              <a:t>CB7-24h-Cell cycle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右箭头 4"/>
          <p:cNvSpPr/>
          <p:nvPr/>
        </p:nvSpPr>
        <p:spPr>
          <a:xfrm>
            <a:off x="392040" y="5681520"/>
            <a:ext cx="8589960" cy="76320"/>
          </a:xfrm>
          <a:prstGeom prst="rightArrow">
            <a:avLst>
              <a:gd name="adj1" fmla="val 50000"/>
              <a:gd name="adj2" fmla="val 50023"/>
            </a:avLst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右箭头 4"/>
          <p:cNvSpPr/>
          <p:nvPr/>
        </p:nvSpPr>
        <p:spPr>
          <a:xfrm>
            <a:off x="336600" y="2836800"/>
            <a:ext cx="8589960" cy="76320"/>
          </a:xfrm>
          <a:prstGeom prst="rightArrow">
            <a:avLst>
              <a:gd name="adj1" fmla="val 50000"/>
              <a:gd name="adj2" fmla="val 50023"/>
            </a:avLst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上箭头 5"/>
          <p:cNvSpPr/>
          <p:nvPr/>
        </p:nvSpPr>
        <p:spPr>
          <a:xfrm>
            <a:off x="317520" y="306360"/>
            <a:ext cx="76320" cy="2543040"/>
          </a:xfrm>
          <a:prstGeom prst="upArrow">
            <a:avLst>
              <a:gd name="adj1" fmla="val 50000"/>
              <a:gd name="adj2" fmla="val 49981"/>
            </a:avLst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TextBox 74"/>
          <p:cNvSpPr/>
          <p:nvPr/>
        </p:nvSpPr>
        <p:spPr>
          <a:xfrm rot="16200000">
            <a:off x="-380880" y="1217880"/>
            <a:ext cx="1038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No. of cells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TextBox 15"/>
          <p:cNvSpPr/>
          <p:nvPr/>
        </p:nvSpPr>
        <p:spPr>
          <a:xfrm>
            <a:off x="8318520" y="5745240"/>
            <a:ext cx="5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I lo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TextBox 75"/>
          <p:cNvSpPr/>
          <p:nvPr/>
        </p:nvSpPr>
        <p:spPr>
          <a:xfrm>
            <a:off x="8199360" y="2919240"/>
            <a:ext cx="5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I lo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39" name="Group 87"/>
          <p:cNvGrpSpPr/>
          <p:nvPr/>
        </p:nvGrpSpPr>
        <p:grpSpPr>
          <a:xfrm>
            <a:off x="452520" y="515880"/>
            <a:ext cx="8928000" cy="2022480"/>
            <a:chOff x="452520" y="515880"/>
            <a:chExt cx="8928000" cy="2022480"/>
          </a:xfrm>
        </p:grpSpPr>
        <p:grpSp>
          <p:nvGrpSpPr>
            <p:cNvPr id="240" name="组合 34"/>
            <p:cNvGrpSpPr/>
            <p:nvPr/>
          </p:nvGrpSpPr>
          <p:grpSpPr>
            <a:xfrm>
              <a:off x="452520" y="515880"/>
              <a:ext cx="8928000" cy="2022480"/>
              <a:chOff x="452520" y="515880"/>
              <a:chExt cx="8928000" cy="2022480"/>
            </a:xfrm>
          </p:grpSpPr>
          <p:grpSp>
            <p:nvGrpSpPr>
              <p:cNvPr id="241" name="组合 28"/>
              <p:cNvGrpSpPr/>
              <p:nvPr/>
            </p:nvGrpSpPr>
            <p:grpSpPr>
              <a:xfrm>
                <a:off x="1087200" y="2226960"/>
                <a:ext cx="8141760" cy="311400"/>
                <a:chOff x="1087200" y="2226960"/>
                <a:chExt cx="8141760" cy="311400"/>
              </a:xfrm>
            </p:grpSpPr>
            <p:grpSp>
              <p:nvGrpSpPr>
                <p:cNvPr id="242" name="组合 38"/>
                <p:cNvGrpSpPr/>
                <p:nvPr/>
              </p:nvGrpSpPr>
              <p:grpSpPr>
                <a:xfrm>
                  <a:off x="1087200" y="2226960"/>
                  <a:ext cx="6398280" cy="299880"/>
                  <a:chOff x="1087200" y="2226960"/>
                  <a:chExt cx="6398280" cy="299880"/>
                </a:xfrm>
              </p:grpSpPr>
              <p:grpSp>
                <p:nvGrpSpPr>
                  <p:cNvPr id="243" name="组合 40"/>
                  <p:cNvGrpSpPr/>
                  <p:nvPr/>
                </p:nvGrpSpPr>
                <p:grpSpPr>
                  <a:xfrm>
                    <a:off x="1087200" y="2226960"/>
                    <a:ext cx="4567320" cy="283320"/>
                    <a:chOff x="1087200" y="2226960"/>
                    <a:chExt cx="4567320" cy="283320"/>
                  </a:xfrm>
                </p:grpSpPr>
                <p:grpSp>
                  <p:nvGrpSpPr>
                    <p:cNvPr id="244" name="组合 42"/>
                    <p:cNvGrpSpPr/>
                    <p:nvPr/>
                  </p:nvGrpSpPr>
                  <p:grpSpPr>
                    <a:xfrm>
                      <a:off x="1087200" y="2226960"/>
                      <a:ext cx="3209400" cy="276480"/>
                      <a:chOff x="1087200" y="2226960"/>
                      <a:chExt cx="3209400" cy="276480"/>
                    </a:xfrm>
                  </p:grpSpPr>
                  <p:sp>
                    <p:nvSpPr>
                      <p:cNvPr id="245" name="文本框 1"/>
                      <p:cNvSpPr/>
                      <p:nvPr/>
                    </p:nvSpPr>
                    <p:spPr>
                      <a:xfrm>
                        <a:off x="1087200" y="2226960"/>
                        <a:ext cx="1029960" cy="27648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spAutoFit/>
                      </a:bodyPr>
                      <a:p>
                        <a:pPr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1" lang="en-US" sz="1200" spc="-1" strike="noStrike">
                            <a:solidFill>
                              <a:srgbClr val="000000"/>
                            </a:solidFill>
                            <a:latin typeface="Arial"/>
                          </a:rPr>
                          <a:t>DMSO</a:t>
                        </a:r>
                        <a:endParaRPr b="0" lang="en-US" sz="12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246" name="文本框 1"/>
                      <p:cNvSpPr/>
                      <p:nvPr/>
                    </p:nvSpPr>
                    <p:spPr>
                      <a:xfrm>
                        <a:off x="2631600" y="2226960"/>
                        <a:ext cx="1665000" cy="27648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spAutoFit/>
                      </a:bodyPr>
                      <a:p>
                        <a:pPr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1" lang="en-US" sz="1200" spc="-1" strike="noStrike">
                            <a:solidFill>
                              <a:srgbClr val="000000"/>
                            </a:solidFill>
                            <a:latin typeface="Arial"/>
                          </a:rPr>
                          <a:t>A1541-0.5</a:t>
                        </a:r>
                        <a:r>
                          <a:rPr b="1" lang="el-GR" sz="1200" spc="-1" strike="noStrike">
                            <a:solidFill>
                              <a:srgbClr val="000000"/>
                            </a:solidFill>
                            <a:latin typeface="Arial"/>
                          </a:rPr>
                          <a:t>μ</a:t>
                        </a:r>
                        <a:r>
                          <a:rPr b="1" lang="en-US" sz="1200" spc="-1" strike="noStrike">
                            <a:solidFill>
                              <a:srgbClr val="000000"/>
                            </a:solidFill>
                            <a:latin typeface="Arial"/>
                          </a:rPr>
                          <a:t>M</a:t>
                        </a:r>
                        <a:endParaRPr b="0" lang="en-US" sz="12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</p:grpSp>
                <p:sp>
                  <p:nvSpPr>
                    <p:cNvPr id="247" name="文本框 1"/>
                    <p:cNvSpPr/>
                    <p:nvPr/>
                  </p:nvSpPr>
                  <p:spPr>
                    <a:xfrm>
                      <a:off x="4251960" y="2233800"/>
                      <a:ext cx="140256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1542-0.5</a:t>
                      </a:r>
                      <a:r>
                        <a:rPr b="1" lang="el-G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μ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248" name="文本框 1"/>
                  <p:cNvSpPr/>
                  <p:nvPr/>
                </p:nvSpPr>
                <p:spPr>
                  <a:xfrm>
                    <a:off x="5977440" y="2250360"/>
                    <a:ext cx="150804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Arial"/>
                      </a:rPr>
                      <a:t>A1543-0.5</a:t>
                    </a:r>
                    <a:r>
                      <a:rPr b="1" lang="el-GR" sz="1200" spc="-1" strike="noStrike">
                        <a:solidFill>
                          <a:srgbClr val="000000"/>
                        </a:solidFill>
                        <a:latin typeface="Arial"/>
                      </a:rPr>
                      <a:t>μ</a:t>
                    </a: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Arial"/>
                      </a:rPr>
                      <a:t>M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249" name="文本框 1"/>
                <p:cNvSpPr/>
                <p:nvPr/>
              </p:nvSpPr>
              <p:spPr>
                <a:xfrm>
                  <a:off x="7570440" y="2261880"/>
                  <a:ext cx="16585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Cedrelone-5</a:t>
                  </a:r>
                  <a:r>
                    <a:rPr b="1" lang="el-GR" sz="1200" spc="-1" strike="noStrike">
                      <a:solidFill>
                        <a:srgbClr val="000000"/>
                      </a:solidFill>
                      <a:latin typeface="Arial"/>
                    </a:rPr>
                    <a:t>μ</a:t>
                  </a: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M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250" name="组合 33"/>
              <p:cNvGrpSpPr/>
              <p:nvPr/>
            </p:nvGrpSpPr>
            <p:grpSpPr>
              <a:xfrm>
                <a:off x="452520" y="515880"/>
                <a:ext cx="8928000" cy="1730880"/>
                <a:chOff x="452520" y="515880"/>
                <a:chExt cx="8928000" cy="1730880"/>
              </a:xfrm>
            </p:grpSpPr>
            <p:grpSp>
              <p:nvGrpSpPr>
                <p:cNvPr id="251" name="组合 9"/>
                <p:cNvGrpSpPr/>
                <p:nvPr/>
              </p:nvGrpSpPr>
              <p:grpSpPr>
                <a:xfrm>
                  <a:off x="452520" y="515880"/>
                  <a:ext cx="1980360" cy="1730880"/>
                  <a:chOff x="452520" y="515880"/>
                  <a:chExt cx="1980360" cy="1730880"/>
                </a:xfrm>
              </p:grpSpPr>
              <p:pic>
                <p:nvPicPr>
                  <p:cNvPr id="252" name="图片 2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452520" y="515880"/>
                    <a:ext cx="1693440" cy="17308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253" name="文本框 36"/>
                  <p:cNvSpPr/>
                  <p:nvPr/>
                </p:nvSpPr>
                <p:spPr>
                  <a:xfrm>
                    <a:off x="1299240" y="715680"/>
                    <a:ext cx="1133640" cy="5054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9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G1:34.88%</a:t>
                    </a:r>
                    <a:endParaRPr b="0" lang="en-US" sz="9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9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S:55.36%</a:t>
                    </a:r>
                    <a:endParaRPr b="0" lang="en-US" sz="9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9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G2:9.77%</a:t>
                    </a:r>
                    <a:endParaRPr b="0" lang="en-US" sz="9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254" name="组合 32"/>
                <p:cNvGrpSpPr/>
                <p:nvPr/>
              </p:nvGrpSpPr>
              <p:grpSpPr>
                <a:xfrm>
                  <a:off x="7241400" y="515880"/>
                  <a:ext cx="2139120" cy="1730880"/>
                  <a:chOff x="7241400" y="515880"/>
                  <a:chExt cx="2139120" cy="1730880"/>
                </a:xfrm>
              </p:grpSpPr>
              <p:pic>
                <p:nvPicPr>
                  <p:cNvPr id="255" name="图片 7" descr=""/>
                  <p:cNvPicPr/>
                  <p:nvPr/>
                </p:nvPicPr>
                <p:blipFill>
                  <a:blip r:embed="rId7"/>
                  <a:stretch/>
                </p:blipFill>
                <p:spPr>
                  <a:xfrm>
                    <a:off x="7241400" y="515880"/>
                    <a:ext cx="1693440" cy="17308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256" name="文本框 50"/>
                  <p:cNvSpPr/>
                  <p:nvPr/>
                </p:nvSpPr>
                <p:spPr>
                  <a:xfrm>
                    <a:off x="8177400" y="788040"/>
                    <a:ext cx="1203120" cy="5054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9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G1:29.68%</a:t>
                    </a:r>
                    <a:endParaRPr b="0" lang="en-US" sz="9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9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S:33.77%</a:t>
                    </a:r>
                    <a:endParaRPr b="0" lang="en-US" sz="9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9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G2:36.49%</a:t>
                    </a:r>
                    <a:endParaRPr b="0" lang="en-US" sz="9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</p:grpSp>
        <p:grpSp>
          <p:nvGrpSpPr>
            <p:cNvPr id="257" name="组合 37"/>
            <p:cNvGrpSpPr/>
            <p:nvPr/>
          </p:nvGrpSpPr>
          <p:grpSpPr>
            <a:xfrm>
              <a:off x="2145960" y="515880"/>
              <a:ext cx="1968840" cy="1730880"/>
              <a:chOff x="2145960" y="515880"/>
              <a:chExt cx="1968840" cy="1730880"/>
            </a:xfrm>
          </p:grpSpPr>
          <p:pic>
            <p:nvPicPr>
              <p:cNvPr id="258" name="图片 51" descr=""/>
              <p:cNvPicPr/>
              <p:nvPr/>
            </p:nvPicPr>
            <p:blipFill>
              <a:blip r:embed="rId8"/>
              <a:stretch/>
            </p:blipFill>
            <p:spPr>
              <a:xfrm>
                <a:off x="2145960" y="515880"/>
                <a:ext cx="1693440" cy="17308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59" name="文本框 52"/>
              <p:cNvSpPr/>
              <p:nvPr/>
            </p:nvSpPr>
            <p:spPr>
              <a:xfrm>
                <a:off x="3053520" y="735480"/>
                <a:ext cx="1061280" cy="505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1:19.20%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:71.42%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2:9.38%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60" name="组合 53"/>
            <p:cNvGrpSpPr/>
            <p:nvPr/>
          </p:nvGrpSpPr>
          <p:grpSpPr>
            <a:xfrm>
              <a:off x="3844440" y="529560"/>
              <a:ext cx="2014560" cy="1730880"/>
              <a:chOff x="3844440" y="529560"/>
              <a:chExt cx="2014560" cy="1730880"/>
            </a:xfrm>
          </p:grpSpPr>
          <p:pic>
            <p:nvPicPr>
              <p:cNvPr id="261" name="图片 54" descr=""/>
              <p:cNvPicPr/>
              <p:nvPr/>
            </p:nvPicPr>
            <p:blipFill>
              <a:blip r:embed="rId9"/>
              <a:stretch/>
            </p:blipFill>
            <p:spPr>
              <a:xfrm>
                <a:off x="3844440" y="529560"/>
                <a:ext cx="1693440" cy="17308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62" name="文本框 55"/>
              <p:cNvSpPr/>
              <p:nvPr/>
            </p:nvSpPr>
            <p:spPr>
              <a:xfrm>
                <a:off x="4797720" y="770760"/>
                <a:ext cx="1061280" cy="505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1:19.27%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:74.11%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2:6.56%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63" name="组合 56"/>
            <p:cNvGrpSpPr/>
            <p:nvPr/>
          </p:nvGrpSpPr>
          <p:grpSpPr>
            <a:xfrm>
              <a:off x="5572440" y="525600"/>
              <a:ext cx="2031480" cy="1730880"/>
              <a:chOff x="5572440" y="525600"/>
              <a:chExt cx="2031480" cy="1730880"/>
            </a:xfrm>
          </p:grpSpPr>
          <p:pic>
            <p:nvPicPr>
              <p:cNvPr id="264" name="图片 57" descr=""/>
              <p:cNvPicPr/>
              <p:nvPr/>
            </p:nvPicPr>
            <p:blipFill>
              <a:blip r:embed="rId10"/>
              <a:stretch/>
            </p:blipFill>
            <p:spPr>
              <a:xfrm>
                <a:off x="5572440" y="525600"/>
                <a:ext cx="1693440" cy="17308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65" name="文本框 58"/>
              <p:cNvSpPr/>
              <p:nvPr/>
            </p:nvSpPr>
            <p:spPr>
              <a:xfrm>
                <a:off x="6463800" y="770760"/>
                <a:ext cx="1140120" cy="505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1:13.86%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:78.38%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2:7.77%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266" name="Straight Connector 5"/>
          <p:cNvSpPr/>
          <p:nvPr/>
        </p:nvSpPr>
        <p:spPr>
          <a:xfrm>
            <a:off x="10909440" y="530280"/>
            <a:ext cx="0" cy="6840360"/>
          </a:xfrm>
          <a:prstGeom prst="line">
            <a:avLst/>
          </a:prstGeom>
          <a:ln w="6480">
            <a:solidFill>
              <a:srgbClr val="bbe0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TextBox 6"/>
          <p:cNvSpPr/>
          <p:nvPr/>
        </p:nvSpPr>
        <p:spPr>
          <a:xfrm>
            <a:off x="214200" y="5900760"/>
            <a:ext cx="873936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l figure 4: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Induction of cell cycle arrest by the compounds in erythroleukemic cells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In HEL (A) and CB7 (B) cells, A1541/43 increase S1 and decrease G1 and G2 phase stages of cell cycle, 24 hour post-drug incubation. Cedrelone in contract increases G2 and decreases G1 and S in both cell lines (A and B)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TextBox 70"/>
          <p:cNvSpPr/>
          <p:nvPr/>
        </p:nvSpPr>
        <p:spPr>
          <a:xfrm>
            <a:off x="456840" y="111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TextBox 71"/>
          <p:cNvSpPr/>
          <p:nvPr/>
        </p:nvSpPr>
        <p:spPr>
          <a:xfrm>
            <a:off x="466200" y="295920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0" name="图片 1" descr=""/>
          <p:cNvPicPr/>
          <p:nvPr/>
        </p:nvPicPr>
        <p:blipFill>
          <a:blip r:embed="rId1"/>
          <a:stretch/>
        </p:blipFill>
        <p:spPr>
          <a:xfrm>
            <a:off x="181080" y="692280"/>
            <a:ext cx="2450880" cy="1662120"/>
          </a:xfrm>
          <a:prstGeom prst="rect">
            <a:avLst/>
          </a:prstGeom>
          <a:ln w="0">
            <a:noFill/>
          </a:ln>
        </p:spPr>
      </p:pic>
      <p:pic>
        <p:nvPicPr>
          <p:cNvPr id="271" name="图片 2" descr=""/>
          <p:cNvPicPr/>
          <p:nvPr/>
        </p:nvPicPr>
        <p:blipFill>
          <a:blip r:embed="rId2"/>
          <a:srcRect l="0" t="8272" r="15764" b="11937"/>
          <a:stretch/>
        </p:blipFill>
        <p:spPr>
          <a:xfrm>
            <a:off x="2631960" y="196920"/>
            <a:ext cx="1613160" cy="1079280"/>
          </a:xfrm>
          <a:prstGeom prst="rect">
            <a:avLst/>
          </a:prstGeom>
          <a:ln w="0">
            <a:noFill/>
          </a:ln>
        </p:spPr>
      </p:pic>
      <p:pic>
        <p:nvPicPr>
          <p:cNvPr id="272" name="图片 3" descr=""/>
          <p:cNvPicPr/>
          <p:nvPr/>
        </p:nvPicPr>
        <p:blipFill>
          <a:blip r:embed="rId3"/>
          <a:srcRect l="34006" t="7729" r="36505" b="13901"/>
          <a:stretch/>
        </p:blipFill>
        <p:spPr>
          <a:xfrm>
            <a:off x="4630680" y="92160"/>
            <a:ext cx="2886120" cy="2581200"/>
          </a:xfrm>
          <a:prstGeom prst="rect">
            <a:avLst/>
          </a:prstGeom>
          <a:ln w="0">
            <a:noFill/>
          </a:ln>
        </p:spPr>
      </p:pic>
      <p:sp>
        <p:nvSpPr>
          <p:cNvPr id="273" name="文本框 4"/>
          <p:cNvSpPr/>
          <p:nvPr/>
        </p:nvSpPr>
        <p:spPr>
          <a:xfrm>
            <a:off x="4232160" y="271440"/>
            <a:ext cx="1131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edrelon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文本框 5"/>
          <p:cNvSpPr/>
          <p:nvPr/>
        </p:nvSpPr>
        <p:spPr>
          <a:xfrm>
            <a:off x="0" y="279360"/>
            <a:ext cx="1131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EQW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75" name="图片 6" descr=""/>
          <p:cNvPicPr/>
          <p:nvPr/>
        </p:nvPicPr>
        <p:blipFill>
          <a:blip r:embed="rId4"/>
          <a:srcRect l="11486" t="17474" r="25417" b="15861"/>
          <a:stretch/>
        </p:blipFill>
        <p:spPr>
          <a:xfrm>
            <a:off x="2825640" y="3800520"/>
            <a:ext cx="2811600" cy="2070000"/>
          </a:xfrm>
          <a:prstGeom prst="rect">
            <a:avLst/>
          </a:prstGeom>
          <a:ln w="0">
            <a:noFill/>
          </a:ln>
        </p:spPr>
      </p:pic>
      <p:pic>
        <p:nvPicPr>
          <p:cNvPr id="276" name="图片 7" descr=""/>
          <p:cNvPicPr/>
          <p:nvPr/>
        </p:nvPicPr>
        <p:blipFill>
          <a:blip r:embed="rId5"/>
          <a:stretch/>
        </p:blipFill>
        <p:spPr>
          <a:xfrm>
            <a:off x="4684680" y="2962440"/>
            <a:ext cx="1522440" cy="723600"/>
          </a:xfrm>
          <a:prstGeom prst="rect">
            <a:avLst/>
          </a:prstGeom>
          <a:ln w="0">
            <a:noFill/>
          </a:ln>
        </p:spPr>
      </p:pic>
      <p:pic>
        <p:nvPicPr>
          <p:cNvPr id="277" name="图片 8" descr=""/>
          <p:cNvPicPr/>
          <p:nvPr/>
        </p:nvPicPr>
        <p:blipFill>
          <a:blip r:embed="rId6"/>
          <a:stretch/>
        </p:blipFill>
        <p:spPr>
          <a:xfrm>
            <a:off x="7378560" y="219240"/>
            <a:ext cx="1641600" cy="1079280"/>
          </a:xfrm>
          <a:prstGeom prst="rect">
            <a:avLst/>
          </a:prstGeom>
          <a:ln w="0">
            <a:noFill/>
          </a:ln>
        </p:spPr>
      </p:pic>
      <p:sp>
        <p:nvSpPr>
          <p:cNvPr id="278" name="文本框 9"/>
          <p:cNvSpPr/>
          <p:nvPr/>
        </p:nvSpPr>
        <p:spPr>
          <a:xfrm>
            <a:off x="3576600" y="3249720"/>
            <a:ext cx="865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154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79" name="图片 10" descr=""/>
          <p:cNvPicPr/>
          <p:nvPr/>
        </p:nvPicPr>
        <p:blipFill>
          <a:blip r:embed="rId7"/>
          <a:srcRect l="26291" t="17217" r="16300" b="21296"/>
          <a:stretch/>
        </p:blipFill>
        <p:spPr>
          <a:xfrm>
            <a:off x="0" y="3773520"/>
            <a:ext cx="2529000" cy="1887480"/>
          </a:xfrm>
          <a:prstGeom prst="rect">
            <a:avLst/>
          </a:prstGeom>
          <a:ln w="0">
            <a:noFill/>
          </a:ln>
        </p:spPr>
      </p:pic>
      <p:pic>
        <p:nvPicPr>
          <p:cNvPr id="280" name="图片 14" descr=""/>
          <p:cNvPicPr/>
          <p:nvPr/>
        </p:nvPicPr>
        <p:blipFill>
          <a:blip r:embed="rId8"/>
          <a:stretch/>
        </p:blipFill>
        <p:spPr>
          <a:xfrm>
            <a:off x="1722600" y="2901960"/>
            <a:ext cx="1446120" cy="820800"/>
          </a:xfrm>
          <a:prstGeom prst="rect">
            <a:avLst/>
          </a:prstGeom>
          <a:ln w="0">
            <a:noFill/>
          </a:ln>
        </p:spPr>
      </p:pic>
      <p:sp>
        <p:nvSpPr>
          <p:cNvPr id="281" name="文本框 15"/>
          <p:cNvSpPr/>
          <p:nvPr/>
        </p:nvSpPr>
        <p:spPr>
          <a:xfrm>
            <a:off x="201600" y="3216240"/>
            <a:ext cx="865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154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82" name="图片 17" descr=""/>
          <p:cNvPicPr/>
          <p:nvPr/>
        </p:nvPicPr>
        <p:blipFill>
          <a:blip r:embed="rId9"/>
          <a:stretch/>
        </p:blipFill>
        <p:spPr>
          <a:xfrm>
            <a:off x="5867280" y="3686040"/>
            <a:ext cx="2592360" cy="2264040"/>
          </a:xfrm>
          <a:prstGeom prst="rect">
            <a:avLst/>
          </a:prstGeom>
          <a:ln w="0">
            <a:noFill/>
          </a:ln>
        </p:spPr>
      </p:pic>
      <p:sp>
        <p:nvSpPr>
          <p:cNvPr id="283" name="文本框 18"/>
          <p:cNvSpPr/>
          <p:nvPr/>
        </p:nvSpPr>
        <p:spPr>
          <a:xfrm>
            <a:off x="6875640" y="3387600"/>
            <a:ext cx="865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154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84" name="图片 22" descr=""/>
          <p:cNvPicPr/>
          <p:nvPr/>
        </p:nvPicPr>
        <p:blipFill>
          <a:blip r:embed="rId10"/>
          <a:srcRect l="0" t="0" r="17537" b="0"/>
          <a:stretch/>
        </p:blipFill>
        <p:spPr>
          <a:xfrm>
            <a:off x="7591320" y="2673360"/>
            <a:ext cx="1414440" cy="1100160"/>
          </a:xfrm>
          <a:prstGeom prst="rect">
            <a:avLst/>
          </a:prstGeom>
          <a:ln w="0">
            <a:noFill/>
          </a:ln>
        </p:spPr>
      </p:pic>
      <p:sp>
        <p:nvSpPr>
          <p:cNvPr id="285" name="TextBox 1"/>
          <p:cNvSpPr/>
          <p:nvPr/>
        </p:nvSpPr>
        <p:spPr>
          <a:xfrm>
            <a:off x="326160" y="5981760"/>
            <a:ext cx="711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l Figure 5: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hemical interaction of the compounds to the indicated ERK1/2 amino-acid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93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3-13T02:59:31Z</dcterms:created>
  <dc:creator>Administrator</dc:creator>
  <dc:description/>
  <dc:language>en-US</dc:language>
  <cp:lastModifiedBy>yaacov ben-david</cp:lastModifiedBy>
  <dcterms:modified xsi:type="dcterms:W3CDTF">2019-06-26T01:04:56Z</dcterms:modified>
  <cp:revision>227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7224</vt:lpwstr>
  </property>
</Properties>
</file>